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1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notesSlides/notesSlide1.xml" ContentType="application/vnd.openxmlformats-officedocument.presentationml.notesSlide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6" r:id="rId2"/>
    <p:sldId id="257" r:id="rId3"/>
    <p:sldId id="262" r:id="rId4"/>
    <p:sldId id="258" r:id="rId5"/>
    <p:sldId id="259" r:id="rId6"/>
    <p:sldId id="260" r:id="rId7"/>
    <p:sldId id="261" r:id="rId8"/>
    <p:sldId id="263" r:id="rId9"/>
  </p:sldIdLst>
  <p:sldSz cx="6119813" cy="86407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980" autoAdjust="0"/>
  </p:normalViewPr>
  <p:slideViewPr>
    <p:cSldViewPr snapToGrid="0">
      <p:cViewPr varScale="1">
        <p:scale>
          <a:sx n="86" d="100"/>
          <a:sy n="86" d="100"/>
        </p:scale>
        <p:origin x="315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research\Data\mRNA\PMA1%20in%20by,tor1,sir2,tor1sir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\Data\RLS\kns1fob1%20del%20background\RLS-kns1Fob1%20del%20background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package" Target="../embeddings/Microsoft_Excel_____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Research\Data\mRNA\DBY,sir2,tor1,sir2tor1\combined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research\Data\mRNA\by,pib2,tor1,gtr1\2610-2018\26%20oct%202018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____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G\Desktop\2019&#45380;%20&#44284;&#51228;\9.%20&#47560;&#50976;%20progress\ag3%204-5,%20BY,%20sir2,%20tor1,%20tor1sir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G\Desktop\2019&#45380;%20&#44284;&#51228;\9.%20&#47560;&#50976;%20progress\ag3%204-5,%20BY,%20sir2,%20tor1,%20tor1sir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research\Data\yeong%20hyock%20data\Final%20DATA\2-2.%20expoenetially%20growing%20cells%20vacuole%20acidity%20(FINAL.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research\Data\mRNA\by,sir2,sch9,sir2sch9\0910-2018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research\Data\mRNA\by,pde2,tor1,pde2tor1\7%20dec%202017-BY,pde2,tor1,pde2tor1\8%20dec%202017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</a:t>
            </a:r>
          </a:p>
        </c:rich>
      </c:tx>
      <c:layout>
        <c:manualLayout>
          <c:xMode val="edge"/>
          <c:yMode val="edge"/>
          <c:x val="0.35521041666666664"/>
          <c:y val="5.6537037037037033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31649999999999995"/>
          <c:y val="0.11276234567901235"/>
          <c:w val="0.63884236111111115"/>
          <c:h val="0.548105555555555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4B3-4100-96A0-891AEEC05AB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4B3-4100-96A0-891AEEC05ABA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4B3-4100-96A0-891AEEC05ABA}"/>
              </c:ext>
            </c:extLst>
          </c:dPt>
          <c:errBars>
            <c:errBarType val="plus"/>
            <c:errValType val="cust"/>
            <c:noEndCap val="0"/>
            <c:plus>
              <c:numRef>
                <c:f>'PMA1(SUM) (2)'!$C$27:$C$30</c:f>
                <c:numCache>
                  <c:formatCode>General</c:formatCode>
                  <c:ptCount val="4"/>
                  <c:pt idx="0">
                    <c:v>6.4615743093186059E-2</c:v>
                  </c:pt>
                  <c:pt idx="1">
                    <c:v>5.6437913267598283E-2</c:v>
                  </c:pt>
                  <c:pt idx="2">
                    <c:v>2.2633226334466516E-2</c:v>
                  </c:pt>
                  <c:pt idx="3">
                    <c:v>9.2812127730768593E-2</c:v>
                  </c:pt>
                </c:numCache>
              </c:numRef>
            </c:plus>
            <c:minus>
              <c:numRef>
                <c:f>'PMA1(SUM) (2)'!$C$27:$C$30</c:f>
                <c:numCache>
                  <c:formatCode>General</c:formatCode>
                  <c:ptCount val="4"/>
                  <c:pt idx="0">
                    <c:v>6.4615743093186059E-2</c:v>
                  </c:pt>
                  <c:pt idx="1">
                    <c:v>5.6437913267598283E-2</c:v>
                  </c:pt>
                  <c:pt idx="2">
                    <c:v>2.2633226334466516E-2</c:v>
                  </c:pt>
                  <c:pt idx="3">
                    <c:v>9.28121277307685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MA1(SUM) (2)'!$B$21:$B$24</c:f>
              <c:strCache>
                <c:ptCount val="4"/>
                <c:pt idx="0">
                  <c:v>WT-DMSO</c:v>
                </c:pt>
                <c:pt idx="1">
                  <c:v>sir2∆-DMSO</c:v>
                </c:pt>
                <c:pt idx="2">
                  <c:v>WT-Rap</c:v>
                </c:pt>
                <c:pt idx="3">
                  <c:v>sir2∆-Rap</c:v>
                </c:pt>
              </c:strCache>
            </c:strRef>
          </c:cat>
          <c:val>
            <c:numRef>
              <c:f>'PMA1(SUM) (2)'!$C$21:$C$24</c:f>
              <c:numCache>
                <c:formatCode>0.00</c:formatCode>
                <c:ptCount val="4"/>
                <c:pt idx="0">
                  <c:v>1.0028508475694951</c:v>
                </c:pt>
                <c:pt idx="1">
                  <c:v>1.3841869556330926</c:v>
                </c:pt>
                <c:pt idx="2">
                  <c:v>0.73638556090971141</c:v>
                </c:pt>
                <c:pt idx="3">
                  <c:v>1.30261731823992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4B3-4100-96A0-891AEEC05A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1927119504"/>
        <c:axId val="1927128240"/>
      </c:barChart>
      <c:catAx>
        <c:axId val="1927119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927128240"/>
        <c:crosses val="autoZero"/>
        <c:auto val="1"/>
        <c:lblAlgn val="ctr"/>
        <c:lblOffset val="100"/>
        <c:noMultiLvlLbl val="0"/>
      </c:catAx>
      <c:valAx>
        <c:axId val="1927128240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  <a:endPara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8.819444444444444E-3"/>
              <c:y val="6.572530864197530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927119504"/>
        <c:crosses val="autoZero"/>
        <c:crossBetween val="between"/>
        <c:majorUnit val="0.5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148361105315193"/>
          <c:y val="0.10616447018946197"/>
          <c:w val="0.66718158540366124"/>
          <c:h val="0.74853797113558862"/>
        </c:manualLayout>
      </c:layout>
      <c:scatterChart>
        <c:scatterStyle val="lineMarker"/>
        <c:varyColors val="0"/>
        <c:ser>
          <c:idx val="1"/>
          <c:order val="0"/>
          <c:tx>
            <c:strRef>
              <c:f>fob1Δ!$H$2</c:f>
              <c:strCache>
                <c:ptCount val="1"/>
                <c:pt idx="0">
                  <c:v>fob1Δ (31.4)</c:v>
                </c:pt>
              </c:strCache>
            </c:strRef>
          </c:tx>
          <c:spPr>
            <a:ln w="12700">
              <a:solidFill>
                <a:srgbClr val="7030A0"/>
              </a:solidFill>
            </a:ln>
          </c:spPr>
          <c:marker>
            <c:symbol val="none"/>
          </c:marker>
          <c:xVal>
            <c:numRef>
              <c:f>fob1Δ!$H$3:$H$23</c:f>
              <c:numCache>
                <c:formatCode>General</c:formatCode>
                <c:ptCount val="21"/>
                <c:pt idx="0">
                  <c:v>0</c:v>
                </c:pt>
                <c:pt idx="1">
                  <c:v>13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  <c:pt idx="7">
                  <c:v>27</c:v>
                </c:pt>
                <c:pt idx="8">
                  <c:v>28</c:v>
                </c:pt>
                <c:pt idx="9">
                  <c:v>29</c:v>
                </c:pt>
                <c:pt idx="10">
                  <c:v>31</c:v>
                </c:pt>
                <c:pt idx="11">
                  <c:v>33</c:v>
                </c:pt>
                <c:pt idx="12">
                  <c:v>35</c:v>
                </c:pt>
                <c:pt idx="13">
                  <c:v>37</c:v>
                </c:pt>
                <c:pt idx="14">
                  <c:v>39</c:v>
                </c:pt>
                <c:pt idx="15">
                  <c:v>41</c:v>
                </c:pt>
                <c:pt idx="16">
                  <c:v>43</c:v>
                </c:pt>
                <c:pt idx="17">
                  <c:v>45</c:v>
                </c:pt>
                <c:pt idx="18">
                  <c:v>46</c:v>
                </c:pt>
                <c:pt idx="19">
                  <c:v>48</c:v>
                </c:pt>
                <c:pt idx="20">
                  <c:v>52</c:v>
                </c:pt>
              </c:numCache>
            </c:numRef>
          </c:xVal>
          <c:yVal>
            <c:numRef>
              <c:f>fob1Δ!$I$3:$I$23</c:f>
              <c:numCache>
                <c:formatCode>0.0</c:formatCode>
                <c:ptCount val="21"/>
                <c:pt idx="0">
                  <c:v>100</c:v>
                </c:pt>
                <c:pt idx="1">
                  <c:v>98.333333333333329</c:v>
                </c:pt>
                <c:pt idx="2">
                  <c:v>95</c:v>
                </c:pt>
                <c:pt idx="3">
                  <c:v>91.6666666666666</c:v>
                </c:pt>
                <c:pt idx="4">
                  <c:v>86.6666666666666</c:v>
                </c:pt>
                <c:pt idx="5">
                  <c:v>76.6666666666666</c:v>
                </c:pt>
                <c:pt idx="6">
                  <c:v>68.333333333333201</c:v>
                </c:pt>
                <c:pt idx="7">
                  <c:v>59.999999999999901</c:v>
                </c:pt>
                <c:pt idx="8">
                  <c:v>58.333333333333201</c:v>
                </c:pt>
                <c:pt idx="9">
                  <c:v>49.999999999999901</c:v>
                </c:pt>
                <c:pt idx="10">
                  <c:v>41.666666666666501</c:v>
                </c:pt>
                <c:pt idx="11">
                  <c:v>36.666666666666501</c:v>
                </c:pt>
                <c:pt idx="12">
                  <c:v>29.999999999999801</c:v>
                </c:pt>
                <c:pt idx="13">
                  <c:v>24.999999999999801</c:v>
                </c:pt>
                <c:pt idx="14">
                  <c:v>19.999999999999801</c:v>
                </c:pt>
                <c:pt idx="15">
                  <c:v>14.999999999999799</c:v>
                </c:pt>
                <c:pt idx="16">
                  <c:v>9.9999999999996998</c:v>
                </c:pt>
                <c:pt idx="17">
                  <c:v>8.3333333333330994</c:v>
                </c:pt>
                <c:pt idx="18">
                  <c:v>3.3333333333330999</c:v>
                </c:pt>
                <c:pt idx="19">
                  <c:v>1.6666666666664001</c:v>
                </c:pt>
                <c:pt idx="2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E94-43EB-93B5-AC4886892766}"/>
            </c:ext>
          </c:extLst>
        </c:ser>
        <c:ser>
          <c:idx val="2"/>
          <c:order val="1"/>
          <c:tx>
            <c:strRef>
              <c:f>fob1Δsir2Δ!$E$3</c:f>
              <c:strCache>
                <c:ptCount val="1"/>
                <c:pt idx="0">
                  <c:v>fob1Δsir2Δ (24.4)</c:v>
                </c:pt>
              </c:strCache>
            </c:strRef>
          </c:tx>
          <c:spPr>
            <a:ln w="12700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xVal>
            <c:numRef>
              <c:f>fob1Δsir2Δ!$E$4:$E$23</c:f>
              <c:numCache>
                <c:formatCode>General</c:formatCode>
                <c:ptCount val="20"/>
                <c:pt idx="0">
                  <c:v>0</c:v>
                </c:pt>
                <c:pt idx="1">
                  <c:v>14</c:v>
                </c:pt>
                <c:pt idx="2">
                  <c:v>15</c:v>
                </c:pt>
                <c:pt idx="3">
                  <c:v>16</c:v>
                </c:pt>
                <c:pt idx="4">
                  <c:v>17</c:v>
                </c:pt>
                <c:pt idx="5">
                  <c:v>18</c:v>
                </c:pt>
                <c:pt idx="6">
                  <c:v>19</c:v>
                </c:pt>
                <c:pt idx="7">
                  <c:v>20</c:v>
                </c:pt>
                <c:pt idx="8">
                  <c:v>21</c:v>
                </c:pt>
                <c:pt idx="9">
                  <c:v>22</c:v>
                </c:pt>
                <c:pt idx="10">
                  <c:v>23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7</c:v>
                </c:pt>
                <c:pt idx="18">
                  <c:v>38</c:v>
                </c:pt>
                <c:pt idx="19">
                  <c:v>40</c:v>
                </c:pt>
              </c:numCache>
            </c:numRef>
          </c:xVal>
          <c:yVal>
            <c:numRef>
              <c:f>fob1Δsir2Δ!$F$4:$F$23</c:f>
              <c:numCache>
                <c:formatCode>General</c:formatCode>
                <c:ptCount val="20"/>
                <c:pt idx="0">
                  <c:v>100</c:v>
                </c:pt>
                <c:pt idx="1">
                  <c:v>96.6</c:v>
                </c:pt>
                <c:pt idx="2">
                  <c:v>93.2</c:v>
                </c:pt>
                <c:pt idx="3">
                  <c:v>91.5</c:v>
                </c:pt>
                <c:pt idx="4">
                  <c:v>89.8</c:v>
                </c:pt>
                <c:pt idx="5">
                  <c:v>86.4</c:v>
                </c:pt>
                <c:pt idx="6">
                  <c:v>79.599999999999994</c:v>
                </c:pt>
                <c:pt idx="7">
                  <c:v>77.900000000000006</c:v>
                </c:pt>
                <c:pt idx="8">
                  <c:v>72.8</c:v>
                </c:pt>
                <c:pt idx="9">
                  <c:v>67.699999999999903</c:v>
                </c:pt>
                <c:pt idx="10">
                  <c:v>62.599999999999902</c:v>
                </c:pt>
                <c:pt idx="11">
                  <c:v>48.999999999999901</c:v>
                </c:pt>
                <c:pt idx="12">
                  <c:v>37.099999999999902</c:v>
                </c:pt>
                <c:pt idx="13">
                  <c:v>26.899999999999899</c:v>
                </c:pt>
                <c:pt idx="14">
                  <c:v>16.6999999999999</c:v>
                </c:pt>
                <c:pt idx="15">
                  <c:v>8.1999999999998003</c:v>
                </c:pt>
                <c:pt idx="16">
                  <c:v>6.4999999999998002</c:v>
                </c:pt>
                <c:pt idx="17">
                  <c:v>3.0999999999997998</c:v>
                </c:pt>
                <c:pt idx="18">
                  <c:v>1.3999999999998101</c:v>
                </c:pt>
                <c:pt idx="1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E94-43EB-93B5-AC4886892766}"/>
            </c:ext>
          </c:extLst>
        </c:ser>
        <c:ser>
          <c:idx val="3"/>
          <c:order val="2"/>
          <c:tx>
            <c:strRef>
              <c:f>fob1Δkns1Δ!$E$2</c:f>
              <c:strCache>
                <c:ptCount val="1"/>
                <c:pt idx="0">
                  <c:v>fob1Δkns1Δ (36.5)</c:v>
                </c:pt>
              </c:strCache>
            </c:strRef>
          </c:tx>
          <c:spPr>
            <a:ln w="127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fob1Δkns1Δ!$E$3:$E$23</c:f>
              <c:numCache>
                <c:formatCode>General</c:formatCode>
                <c:ptCount val="21"/>
                <c:pt idx="0">
                  <c:v>0</c:v>
                </c:pt>
                <c:pt idx="1">
                  <c:v>14</c:v>
                </c:pt>
                <c:pt idx="2">
                  <c:v>20</c:v>
                </c:pt>
                <c:pt idx="3">
                  <c:v>22</c:v>
                </c:pt>
                <c:pt idx="4">
                  <c:v>24</c:v>
                </c:pt>
                <c:pt idx="5">
                  <c:v>27</c:v>
                </c:pt>
                <c:pt idx="6">
                  <c:v>29</c:v>
                </c:pt>
                <c:pt idx="7">
                  <c:v>30</c:v>
                </c:pt>
                <c:pt idx="8">
                  <c:v>32</c:v>
                </c:pt>
                <c:pt idx="9">
                  <c:v>33</c:v>
                </c:pt>
                <c:pt idx="10">
                  <c:v>34</c:v>
                </c:pt>
                <c:pt idx="11">
                  <c:v>35</c:v>
                </c:pt>
                <c:pt idx="12">
                  <c:v>37</c:v>
                </c:pt>
                <c:pt idx="13">
                  <c:v>39</c:v>
                </c:pt>
                <c:pt idx="14">
                  <c:v>41</c:v>
                </c:pt>
                <c:pt idx="15">
                  <c:v>43</c:v>
                </c:pt>
                <c:pt idx="16">
                  <c:v>45</c:v>
                </c:pt>
                <c:pt idx="17">
                  <c:v>47</c:v>
                </c:pt>
                <c:pt idx="18">
                  <c:v>50</c:v>
                </c:pt>
                <c:pt idx="19">
                  <c:v>55</c:v>
                </c:pt>
                <c:pt idx="20">
                  <c:v>60</c:v>
                </c:pt>
              </c:numCache>
            </c:numRef>
          </c:xVal>
          <c:yVal>
            <c:numRef>
              <c:f>fob1Δkns1Δ!$F$3:$F$23</c:f>
              <c:numCache>
                <c:formatCode>General</c:formatCode>
                <c:ptCount val="21"/>
                <c:pt idx="0">
                  <c:v>100</c:v>
                </c:pt>
                <c:pt idx="1">
                  <c:v>98.33</c:v>
                </c:pt>
                <c:pt idx="2">
                  <c:v>94.99</c:v>
                </c:pt>
                <c:pt idx="3">
                  <c:v>91.65</c:v>
                </c:pt>
                <c:pt idx="4">
                  <c:v>86.64</c:v>
                </c:pt>
                <c:pt idx="5">
                  <c:v>79.959999999999994</c:v>
                </c:pt>
                <c:pt idx="6">
                  <c:v>76.62</c:v>
                </c:pt>
                <c:pt idx="7">
                  <c:v>73.28</c:v>
                </c:pt>
                <c:pt idx="8">
                  <c:v>66.599999999999994</c:v>
                </c:pt>
                <c:pt idx="9">
                  <c:v>61.59</c:v>
                </c:pt>
                <c:pt idx="10">
                  <c:v>58.25</c:v>
                </c:pt>
                <c:pt idx="11">
                  <c:v>54.91</c:v>
                </c:pt>
                <c:pt idx="12">
                  <c:v>46.559999999999903</c:v>
                </c:pt>
                <c:pt idx="13">
                  <c:v>38.209999999999901</c:v>
                </c:pt>
                <c:pt idx="14">
                  <c:v>28.189999999999898</c:v>
                </c:pt>
                <c:pt idx="15">
                  <c:v>19.8399999999999</c:v>
                </c:pt>
                <c:pt idx="16">
                  <c:v>13.159999999999901</c:v>
                </c:pt>
                <c:pt idx="17">
                  <c:v>8.1499999999999098</c:v>
                </c:pt>
                <c:pt idx="18">
                  <c:v>3.1399999999999002</c:v>
                </c:pt>
                <c:pt idx="19">
                  <c:v>1.4699999999999001</c:v>
                </c:pt>
                <c:pt idx="2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E94-43EB-93B5-AC4886892766}"/>
            </c:ext>
          </c:extLst>
        </c:ser>
        <c:ser>
          <c:idx val="0"/>
          <c:order val="3"/>
          <c:tx>
            <c:strRef>
              <c:f>fob1Δsir2Δkns1Δ!$G$1</c:f>
              <c:strCache>
                <c:ptCount val="1"/>
                <c:pt idx="0">
                  <c:v>fob1Δsir2Δkns1Δ (31.1)</c:v>
                </c:pt>
              </c:strCache>
            </c:strRef>
          </c:tx>
          <c:spPr>
            <a:ln w="1270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fob1Δsir2Δkns1Δ!$G$2:$G$17</c:f>
              <c:numCache>
                <c:formatCode>General</c:formatCode>
                <c:ptCount val="16"/>
                <c:pt idx="0">
                  <c:v>0</c:v>
                </c:pt>
                <c:pt idx="1">
                  <c:v>13</c:v>
                </c:pt>
                <c:pt idx="2">
                  <c:v>18</c:v>
                </c:pt>
                <c:pt idx="3">
                  <c:v>20</c:v>
                </c:pt>
                <c:pt idx="4">
                  <c:v>23</c:v>
                </c:pt>
                <c:pt idx="5">
                  <c:v>25</c:v>
                </c:pt>
                <c:pt idx="6">
                  <c:v>27</c:v>
                </c:pt>
                <c:pt idx="7">
                  <c:v>29</c:v>
                </c:pt>
                <c:pt idx="8">
                  <c:v>30</c:v>
                </c:pt>
                <c:pt idx="9">
                  <c:v>32</c:v>
                </c:pt>
                <c:pt idx="10">
                  <c:v>34</c:v>
                </c:pt>
                <c:pt idx="11">
                  <c:v>36</c:v>
                </c:pt>
                <c:pt idx="12">
                  <c:v>38</c:v>
                </c:pt>
                <c:pt idx="13">
                  <c:v>40</c:v>
                </c:pt>
                <c:pt idx="14">
                  <c:v>44</c:v>
                </c:pt>
                <c:pt idx="15">
                  <c:v>50</c:v>
                </c:pt>
              </c:numCache>
            </c:numRef>
          </c:xVal>
          <c:yVal>
            <c:numRef>
              <c:f>fob1Δsir2Δkns1Δ!$H$2:$H$17</c:f>
              <c:numCache>
                <c:formatCode>General</c:formatCode>
                <c:ptCount val="16"/>
                <c:pt idx="0">
                  <c:v>100</c:v>
                </c:pt>
                <c:pt idx="1">
                  <c:v>98.33</c:v>
                </c:pt>
                <c:pt idx="2">
                  <c:v>96.66</c:v>
                </c:pt>
                <c:pt idx="3">
                  <c:v>93.32</c:v>
                </c:pt>
                <c:pt idx="4">
                  <c:v>84.97</c:v>
                </c:pt>
                <c:pt idx="5">
                  <c:v>76.62</c:v>
                </c:pt>
                <c:pt idx="6">
                  <c:v>64.930000000000007</c:v>
                </c:pt>
                <c:pt idx="7">
                  <c:v>54.91</c:v>
                </c:pt>
                <c:pt idx="8">
                  <c:v>46.559999999999903</c:v>
                </c:pt>
                <c:pt idx="9">
                  <c:v>36.5399999999999</c:v>
                </c:pt>
                <c:pt idx="10">
                  <c:v>28.189999999999898</c:v>
                </c:pt>
                <c:pt idx="11">
                  <c:v>19.8399999999999</c:v>
                </c:pt>
                <c:pt idx="12">
                  <c:v>14.829999999999901</c:v>
                </c:pt>
                <c:pt idx="13">
                  <c:v>9.8199999999998902</c:v>
                </c:pt>
                <c:pt idx="14">
                  <c:v>1.4699999999999001</c:v>
                </c:pt>
                <c:pt idx="1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E94-43EB-93B5-AC48868927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0248528"/>
        <c:axId val="480249704"/>
      </c:scatterChart>
      <c:valAx>
        <c:axId val="480248528"/>
        <c:scaling>
          <c:orientation val="minMax"/>
          <c:max val="6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en-US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divisions</a:t>
                </a:r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1300986332199138"/>
              <c:y val="0.9196873498090203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80249704"/>
        <c:crosses val="autoZero"/>
        <c:crossBetween val="midCat"/>
        <c:majorUnit val="20"/>
      </c:valAx>
      <c:valAx>
        <c:axId val="4802497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rvival (%)</a:t>
                </a:r>
              </a:p>
            </c:rich>
          </c:tx>
          <c:layout>
            <c:manualLayout>
              <c:xMode val="edge"/>
              <c:yMode val="edge"/>
              <c:x val="1.408972222222222E-2"/>
              <c:y val="0.34009555555555554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80248528"/>
        <c:crosses val="autoZero"/>
        <c:crossBetween val="midCat"/>
        <c:majorUnit val="25"/>
      </c:valAx>
      <c:spPr>
        <a:ln w="12700">
          <a:noFill/>
        </a:ln>
      </c:spPr>
    </c:plotArea>
    <c:legend>
      <c:legendPos val="r"/>
      <c:layout>
        <c:manualLayout>
          <c:xMode val="edge"/>
          <c:yMode val="edge"/>
          <c:x val="0.47877452912875901"/>
          <c:y val="2.5858755812824402E-2"/>
          <c:w val="0.51654910035939705"/>
          <c:h val="0.2592448285344298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/>
      </a:pPr>
      <a:endParaRPr lang="ko-KR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355542465693656"/>
          <c:y val="0.10072026391997539"/>
          <c:w val="0.65710111612123656"/>
          <c:h val="0.75633803418803425"/>
        </c:manualLayout>
      </c:layout>
      <c:scatterChart>
        <c:scatterStyle val="lineMarker"/>
        <c:varyColors val="0"/>
        <c:ser>
          <c:idx val="1"/>
          <c:order val="0"/>
          <c:tx>
            <c:strRef>
              <c:f>'Combined data'!$B$2</c:f>
              <c:strCache>
                <c:ptCount val="1"/>
                <c:pt idx="0">
                  <c:v>fob1∆(30.4)</c:v>
                </c:pt>
              </c:strCache>
            </c:strRef>
          </c:tx>
          <c:spPr>
            <a:ln w="12700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xVal>
            <c:numRef>
              <c:f>fob1∆!$B$3:$B$29</c:f>
              <c:numCache>
                <c:formatCode>General</c:formatCode>
                <c:ptCount val="27"/>
                <c:pt idx="0">
                  <c:v>0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20</c:v>
                </c:pt>
                <c:pt idx="6">
                  <c:v>23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  <c:pt idx="17">
                  <c:v>36</c:v>
                </c:pt>
                <c:pt idx="18">
                  <c:v>37</c:v>
                </c:pt>
                <c:pt idx="19">
                  <c:v>38</c:v>
                </c:pt>
                <c:pt idx="20">
                  <c:v>40</c:v>
                </c:pt>
                <c:pt idx="21">
                  <c:v>41</c:v>
                </c:pt>
                <c:pt idx="22">
                  <c:v>42</c:v>
                </c:pt>
                <c:pt idx="23">
                  <c:v>43</c:v>
                </c:pt>
                <c:pt idx="24">
                  <c:v>44</c:v>
                </c:pt>
                <c:pt idx="25">
                  <c:v>47</c:v>
                </c:pt>
                <c:pt idx="26">
                  <c:v>48</c:v>
                </c:pt>
              </c:numCache>
            </c:numRef>
          </c:xVal>
          <c:yVal>
            <c:numRef>
              <c:f>fob1∆!$C$3:$C$29</c:f>
              <c:numCache>
                <c:formatCode>General</c:formatCode>
                <c:ptCount val="27"/>
                <c:pt idx="0">
                  <c:v>100</c:v>
                </c:pt>
                <c:pt idx="1">
                  <c:v>98.591549295774655</c:v>
                </c:pt>
                <c:pt idx="2">
                  <c:v>97.183098591549296</c:v>
                </c:pt>
                <c:pt idx="3">
                  <c:v>94.366197183098592</c:v>
                </c:pt>
                <c:pt idx="4">
                  <c:v>91.549295774647888</c:v>
                </c:pt>
                <c:pt idx="5">
                  <c:v>85.91549295774648</c:v>
                </c:pt>
                <c:pt idx="6">
                  <c:v>80.281690140845072</c:v>
                </c:pt>
                <c:pt idx="7">
                  <c:v>78.873239436619713</c:v>
                </c:pt>
                <c:pt idx="8">
                  <c:v>71.83098591549296</c:v>
                </c:pt>
                <c:pt idx="9">
                  <c:v>69.014084507042256</c:v>
                </c:pt>
                <c:pt idx="10">
                  <c:v>60.563380281690137</c:v>
                </c:pt>
                <c:pt idx="11">
                  <c:v>52.112676056338024</c:v>
                </c:pt>
                <c:pt idx="12">
                  <c:v>50.704225352112672</c:v>
                </c:pt>
                <c:pt idx="13">
                  <c:v>43.661971830985912</c:v>
                </c:pt>
                <c:pt idx="14">
                  <c:v>35.2112676056338</c:v>
                </c:pt>
                <c:pt idx="15">
                  <c:v>30.985915492957744</c:v>
                </c:pt>
                <c:pt idx="16">
                  <c:v>26.760563380281688</c:v>
                </c:pt>
                <c:pt idx="17">
                  <c:v>16.901408450704224</c:v>
                </c:pt>
                <c:pt idx="18">
                  <c:v>14.084507042253522</c:v>
                </c:pt>
                <c:pt idx="19">
                  <c:v>12.676056338028168</c:v>
                </c:pt>
                <c:pt idx="20">
                  <c:v>11.267605633802818</c:v>
                </c:pt>
                <c:pt idx="21">
                  <c:v>8.4507042253521121</c:v>
                </c:pt>
                <c:pt idx="22">
                  <c:v>7.042253521126761</c:v>
                </c:pt>
                <c:pt idx="23">
                  <c:v>5.6338028169014089</c:v>
                </c:pt>
                <c:pt idx="24">
                  <c:v>4.225352112676056</c:v>
                </c:pt>
                <c:pt idx="25">
                  <c:v>1.4084507042253522</c:v>
                </c:pt>
                <c:pt idx="26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E51-471F-801C-78F18B404EC1}"/>
            </c:ext>
          </c:extLst>
        </c:ser>
        <c:ser>
          <c:idx val="2"/>
          <c:order val="1"/>
          <c:tx>
            <c:strRef>
              <c:f>'Combined data'!$C$2</c:f>
              <c:strCache>
                <c:ptCount val="1"/>
                <c:pt idx="0">
                  <c:v>fob1∆sir2∆(23.29)</c:v>
                </c:pt>
              </c:strCache>
            </c:strRef>
          </c:tx>
          <c:spPr>
            <a:ln w="12700" cap="rnd">
              <a:solidFill>
                <a:srgbClr val="ED7D31"/>
              </a:solidFill>
              <a:round/>
            </a:ln>
            <a:effectLst/>
          </c:spPr>
          <c:marker>
            <c:symbol val="none"/>
          </c:marker>
          <c:xVal>
            <c:numRef>
              <c:f>fob1∆Sir2∆!$B$5:$B$24</c:f>
              <c:numCache>
                <c:formatCode>General</c:formatCode>
                <c:ptCount val="20"/>
                <c:pt idx="0">
                  <c:v>0</c:v>
                </c:pt>
                <c:pt idx="1">
                  <c:v>11</c:v>
                </c:pt>
                <c:pt idx="2">
                  <c:v>14</c:v>
                </c:pt>
                <c:pt idx="3">
                  <c:v>16</c:v>
                </c:pt>
                <c:pt idx="4">
                  <c:v>17</c:v>
                </c:pt>
                <c:pt idx="5">
                  <c:v>18</c:v>
                </c:pt>
                <c:pt idx="6">
                  <c:v>19</c:v>
                </c:pt>
                <c:pt idx="7">
                  <c:v>20</c:v>
                </c:pt>
                <c:pt idx="8">
                  <c:v>21</c:v>
                </c:pt>
                <c:pt idx="9">
                  <c:v>22</c:v>
                </c:pt>
                <c:pt idx="10">
                  <c:v>23</c:v>
                </c:pt>
                <c:pt idx="11">
                  <c:v>24</c:v>
                </c:pt>
                <c:pt idx="12">
                  <c:v>25</c:v>
                </c:pt>
                <c:pt idx="13">
                  <c:v>26</c:v>
                </c:pt>
                <c:pt idx="14">
                  <c:v>27</c:v>
                </c:pt>
                <c:pt idx="15">
                  <c:v>28</c:v>
                </c:pt>
                <c:pt idx="16">
                  <c:v>29</c:v>
                </c:pt>
                <c:pt idx="17">
                  <c:v>30</c:v>
                </c:pt>
                <c:pt idx="18">
                  <c:v>31</c:v>
                </c:pt>
                <c:pt idx="19">
                  <c:v>33</c:v>
                </c:pt>
              </c:numCache>
            </c:numRef>
          </c:xVal>
          <c:yVal>
            <c:numRef>
              <c:f>fob1∆Sir2∆!$C$5:$C$24</c:f>
              <c:numCache>
                <c:formatCode>General</c:formatCode>
                <c:ptCount val="20"/>
                <c:pt idx="0">
                  <c:v>100</c:v>
                </c:pt>
                <c:pt idx="1">
                  <c:v>98.611111111111114</c:v>
                </c:pt>
                <c:pt idx="2">
                  <c:v>94.444444444444443</c:v>
                </c:pt>
                <c:pt idx="3">
                  <c:v>90.277777777777786</c:v>
                </c:pt>
                <c:pt idx="4">
                  <c:v>84.722222222222214</c:v>
                </c:pt>
                <c:pt idx="5">
                  <c:v>83.333333333333343</c:v>
                </c:pt>
                <c:pt idx="6">
                  <c:v>79.166666666666657</c:v>
                </c:pt>
                <c:pt idx="7">
                  <c:v>72.222222222222214</c:v>
                </c:pt>
                <c:pt idx="8">
                  <c:v>66.666666666666657</c:v>
                </c:pt>
                <c:pt idx="9">
                  <c:v>55.555555555555557</c:v>
                </c:pt>
                <c:pt idx="10">
                  <c:v>47.222222222222221</c:v>
                </c:pt>
                <c:pt idx="11">
                  <c:v>41.666666666666671</c:v>
                </c:pt>
                <c:pt idx="12">
                  <c:v>30.555555555555557</c:v>
                </c:pt>
                <c:pt idx="13">
                  <c:v>26.388888888888889</c:v>
                </c:pt>
                <c:pt idx="14">
                  <c:v>22.222222222222221</c:v>
                </c:pt>
                <c:pt idx="15">
                  <c:v>19.444444444444446</c:v>
                </c:pt>
                <c:pt idx="16">
                  <c:v>12.5</c:v>
                </c:pt>
                <c:pt idx="17">
                  <c:v>6.9444444444444446</c:v>
                </c:pt>
                <c:pt idx="18">
                  <c:v>2.7777777777777777</c:v>
                </c:pt>
                <c:pt idx="1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E51-471F-801C-78F18B404EC1}"/>
            </c:ext>
          </c:extLst>
        </c:ser>
        <c:ser>
          <c:idx val="3"/>
          <c:order val="2"/>
          <c:tx>
            <c:strRef>
              <c:f>'Combined data'!$D$2</c:f>
              <c:strCache>
                <c:ptCount val="1"/>
                <c:pt idx="0">
                  <c:v>fob1∆tor1∆(40.4)</c:v>
                </c:pt>
              </c:strCache>
            </c:strRef>
          </c:tx>
          <c:spPr>
            <a:ln w="127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fob1∆tor1∆!$B$3:$B$33</c:f>
              <c:numCache>
                <c:formatCode>General</c:formatCode>
                <c:ptCount val="31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28</c:v>
                </c:pt>
                <c:pt idx="5">
                  <c:v>29</c:v>
                </c:pt>
                <c:pt idx="6">
                  <c:v>30</c:v>
                </c:pt>
                <c:pt idx="7">
                  <c:v>31</c:v>
                </c:pt>
                <c:pt idx="8">
                  <c:v>32</c:v>
                </c:pt>
                <c:pt idx="9">
                  <c:v>33</c:v>
                </c:pt>
                <c:pt idx="10">
                  <c:v>34</c:v>
                </c:pt>
                <c:pt idx="11">
                  <c:v>35</c:v>
                </c:pt>
                <c:pt idx="12">
                  <c:v>36</c:v>
                </c:pt>
                <c:pt idx="13">
                  <c:v>37</c:v>
                </c:pt>
                <c:pt idx="14">
                  <c:v>38</c:v>
                </c:pt>
                <c:pt idx="15">
                  <c:v>39</c:v>
                </c:pt>
                <c:pt idx="16">
                  <c:v>40</c:v>
                </c:pt>
                <c:pt idx="17">
                  <c:v>41</c:v>
                </c:pt>
                <c:pt idx="18">
                  <c:v>42</c:v>
                </c:pt>
                <c:pt idx="19">
                  <c:v>43</c:v>
                </c:pt>
                <c:pt idx="20">
                  <c:v>44</c:v>
                </c:pt>
                <c:pt idx="21">
                  <c:v>45</c:v>
                </c:pt>
                <c:pt idx="22">
                  <c:v>46</c:v>
                </c:pt>
                <c:pt idx="23">
                  <c:v>47</c:v>
                </c:pt>
                <c:pt idx="24">
                  <c:v>49</c:v>
                </c:pt>
                <c:pt idx="25">
                  <c:v>50</c:v>
                </c:pt>
                <c:pt idx="26">
                  <c:v>52</c:v>
                </c:pt>
                <c:pt idx="27">
                  <c:v>55</c:v>
                </c:pt>
                <c:pt idx="28">
                  <c:v>57</c:v>
                </c:pt>
                <c:pt idx="29">
                  <c:v>58</c:v>
                </c:pt>
                <c:pt idx="30">
                  <c:v>60</c:v>
                </c:pt>
              </c:numCache>
            </c:numRef>
          </c:xVal>
          <c:yVal>
            <c:numRef>
              <c:f>fob1∆tor1∆!$C$3:$C$33</c:f>
              <c:numCache>
                <c:formatCode>General</c:formatCode>
                <c:ptCount val="31"/>
                <c:pt idx="0">
                  <c:v>100</c:v>
                </c:pt>
                <c:pt idx="1">
                  <c:v>97.142857142857139</c:v>
                </c:pt>
                <c:pt idx="2">
                  <c:v>95.714285714285722</c:v>
                </c:pt>
                <c:pt idx="3">
                  <c:v>94.285714285714278</c:v>
                </c:pt>
                <c:pt idx="4">
                  <c:v>92.857142857142861</c:v>
                </c:pt>
                <c:pt idx="5">
                  <c:v>90</c:v>
                </c:pt>
                <c:pt idx="6">
                  <c:v>87.142857142857139</c:v>
                </c:pt>
                <c:pt idx="7">
                  <c:v>84.285714285714292</c:v>
                </c:pt>
                <c:pt idx="8">
                  <c:v>78.571428571428569</c:v>
                </c:pt>
                <c:pt idx="9">
                  <c:v>75.714285714285708</c:v>
                </c:pt>
                <c:pt idx="10">
                  <c:v>74.285714285714292</c:v>
                </c:pt>
                <c:pt idx="11">
                  <c:v>70</c:v>
                </c:pt>
                <c:pt idx="12">
                  <c:v>67.142857142857139</c:v>
                </c:pt>
                <c:pt idx="13">
                  <c:v>65.714285714285708</c:v>
                </c:pt>
                <c:pt idx="14">
                  <c:v>64.285714285714292</c:v>
                </c:pt>
                <c:pt idx="15">
                  <c:v>58.571428571428577</c:v>
                </c:pt>
                <c:pt idx="16">
                  <c:v>55.714285714285715</c:v>
                </c:pt>
                <c:pt idx="17">
                  <c:v>52.857142857142861</c:v>
                </c:pt>
                <c:pt idx="18">
                  <c:v>44.285714285714285</c:v>
                </c:pt>
                <c:pt idx="19">
                  <c:v>34.285714285714285</c:v>
                </c:pt>
                <c:pt idx="20">
                  <c:v>31.428571428571427</c:v>
                </c:pt>
                <c:pt idx="21">
                  <c:v>22.857142857142858</c:v>
                </c:pt>
                <c:pt idx="22">
                  <c:v>20</c:v>
                </c:pt>
                <c:pt idx="23">
                  <c:v>17.142857142857142</c:v>
                </c:pt>
                <c:pt idx="24">
                  <c:v>14.285714285714285</c:v>
                </c:pt>
                <c:pt idx="25">
                  <c:v>8.5714285714285712</c:v>
                </c:pt>
                <c:pt idx="26">
                  <c:v>5.7142857142857144</c:v>
                </c:pt>
                <c:pt idx="27">
                  <c:v>4.2857142857142856</c:v>
                </c:pt>
                <c:pt idx="28">
                  <c:v>2.8571428571428572</c:v>
                </c:pt>
                <c:pt idx="29">
                  <c:v>1.4285714285714286</c:v>
                </c:pt>
                <c:pt idx="3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E51-471F-801C-78F18B404EC1}"/>
            </c:ext>
          </c:extLst>
        </c:ser>
        <c:ser>
          <c:idx val="0"/>
          <c:order val="3"/>
          <c:tx>
            <c:strRef>
              <c:f>'Combined data'!$E$2</c:f>
              <c:strCache>
                <c:ptCount val="1"/>
                <c:pt idx="0">
                  <c:v>fob1∆sir2∆tor1∆(32)</c:v>
                </c:pt>
              </c:strCache>
            </c:strRef>
          </c:tx>
          <c:spPr>
            <a:ln w="1270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fob1∆Sir2∆tor1∆!$B$2:$B$25</c:f>
              <c:numCache>
                <c:formatCode>General</c:formatCode>
                <c:ptCount val="24"/>
                <c:pt idx="0">
                  <c:v>0</c:v>
                </c:pt>
                <c:pt idx="1">
                  <c:v>12</c:v>
                </c:pt>
                <c:pt idx="2">
                  <c:v>20</c:v>
                </c:pt>
                <c:pt idx="3">
                  <c:v>22</c:v>
                </c:pt>
                <c:pt idx="4">
                  <c:v>23</c:v>
                </c:pt>
                <c:pt idx="5">
                  <c:v>24</c:v>
                </c:pt>
                <c:pt idx="6">
                  <c:v>25</c:v>
                </c:pt>
                <c:pt idx="7">
                  <c:v>26</c:v>
                </c:pt>
                <c:pt idx="8">
                  <c:v>27</c:v>
                </c:pt>
                <c:pt idx="9">
                  <c:v>28</c:v>
                </c:pt>
                <c:pt idx="10">
                  <c:v>29</c:v>
                </c:pt>
                <c:pt idx="11">
                  <c:v>30</c:v>
                </c:pt>
                <c:pt idx="12">
                  <c:v>31</c:v>
                </c:pt>
                <c:pt idx="13">
                  <c:v>32</c:v>
                </c:pt>
                <c:pt idx="14">
                  <c:v>33</c:v>
                </c:pt>
                <c:pt idx="15">
                  <c:v>34</c:v>
                </c:pt>
                <c:pt idx="16">
                  <c:v>35</c:v>
                </c:pt>
                <c:pt idx="17">
                  <c:v>36</c:v>
                </c:pt>
                <c:pt idx="18">
                  <c:v>37</c:v>
                </c:pt>
                <c:pt idx="19">
                  <c:v>38</c:v>
                </c:pt>
                <c:pt idx="20">
                  <c:v>40</c:v>
                </c:pt>
                <c:pt idx="21">
                  <c:v>41</c:v>
                </c:pt>
                <c:pt idx="22">
                  <c:v>48</c:v>
                </c:pt>
                <c:pt idx="23">
                  <c:v>50</c:v>
                </c:pt>
              </c:numCache>
            </c:numRef>
          </c:xVal>
          <c:yVal>
            <c:numRef>
              <c:f>fob1∆Sir2∆tor1∆!$C$2:$C$25</c:f>
              <c:numCache>
                <c:formatCode>General</c:formatCode>
                <c:ptCount val="24"/>
                <c:pt idx="0">
                  <c:v>100</c:v>
                </c:pt>
                <c:pt idx="1">
                  <c:v>98.611111111111114</c:v>
                </c:pt>
                <c:pt idx="2">
                  <c:v>97.222222222222214</c:v>
                </c:pt>
                <c:pt idx="3">
                  <c:v>94.444444444444443</c:v>
                </c:pt>
                <c:pt idx="4">
                  <c:v>93.055555555555557</c:v>
                </c:pt>
                <c:pt idx="5">
                  <c:v>91.666666666666657</c:v>
                </c:pt>
                <c:pt idx="6">
                  <c:v>90.277777777777786</c:v>
                </c:pt>
                <c:pt idx="7">
                  <c:v>88.888888888888886</c:v>
                </c:pt>
                <c:pt idx="8">
                  <c:v>87.5</c:v>
                </c:pt>
                <c:pt idx="9">
                  <c:v>79.166666666666657</c:v>
                </c:pt>
                <c:pt idx="10">
                  <c:v>70.833333333333343</c:v>
                </c:pt>
                <c:pt idx="11">
                  <c:v>59.722222222222221</c:v>
                </c:pt>
                <c:pt idx="12">
                  <c:v>51.388888888888886</c:v>
                </c:pt>
                <c:pt idx="13">
                  <c:v>48.611111111111107</c:v>
                </c:pt>
                <c:pt idx="14">
                  <c:v>37.5</c:v>
                </c:pt>
                <c:pt idx="15">
                  <c:v>26.388888888888889</c:v>
                </c:pt>
                <c:pt idx="16">
                  <c:v>19.444444444444446</c:v>
                </c:pt>
                <c:pt idx="17">
                  <c:v>16.666666666666664</c:v>
                </c:pt>
                <c:pt idx="18">
                  <c:v>12.5</c:v>
                </c:pt>
                <c:pt idx="19">
                  <c:v>9.7222222222222232</c:v>
                </c:pt>
                <c:pt idx="20">
                  <c:v>6.9444444444444446</c:v>
                </c:pt>
                <c:pt idx="21">
                  <c:v>2.7777777777777777</c:v>
                </c:pt>
                <c:pt idx="22">
                  <c:v>1.3888888888888888</c:v>
                </c:pt>
                <c:pt idx="23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E51-471F-801C-78F18B404E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4553048"/>
        <c:axId val="384552656"/>
      </c:scatterChart>
      <c:valAx>
        <c:axId val="384553048"/>
        <c:scaling>
          <c:orientation val="minMax"/>
          <c:max val="60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 b="1"/>
                  <a:t>Number of divisions</a:t>
                </a:r>
              </a:p>
            </c:rich>
          </c:tx>
          <c:layout>
            <c:manualLayout>
              <c:xMode val="edge"/>
              <c:yMode val="edge"/>
              <c:x val="0.31833205128205133"/>
              <c:y val="0.921303418803418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ctr" rtl="0"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84552656"/>
        <c:crosses val="autoZero"/>
        <c:crossBetween val="midCat"/>
        <c:majorUnit val="20"/>
      </c:valAx>
      <c:valAx>
        <c:axId val="38455265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 b="1"/>
                  <a:t>Survival (%)</a:t>
                </a:r>
              </a:p>
            </c:rich>
          </c:tx>
          <c:layout>
            <c:manualLayout>
              <c:xMode val="edge"/>
              <c:yMode val="edge"/>
              <c:x val="1.0956444058637988E-2"/>
              <c:y val="0.349598089958327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_);[Red]\(0\)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84553048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53873316928904058"/>
          <c:y val="2.0611111111111108E-2"/>
          <c:w val="0.46126683071095936"/>
          <c:h val="0.25088064442690999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</a:t>
            </a:r>
          </a:p>
        </c:rich>
      </c:tx>
      <c:layout>
        <c:manualLayout>
          <c:xMode val="edge"/>
          <c:yMode val="edge"/>
          <c:x val="0.34928263888888883"/>
          <c:y val="2.9135802469135803E-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3369104166666666"/>
          <c:y val="0.11367283950617284"/>
          <c:w val="0.60135347222222224"/>
          <c:h val="0.583591975308642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15D-46E0-B07F-A467DD52D1CB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15D-46E0-B07F-A467DD52D1CB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15D-46E0-B07F-A467DD52D1CB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15D-46E0-B07F-A467DD52D1CB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C$45:$F$45</c:f>
                <c:numCache>
                  <c:formatCode>General</c:formatCode>
                  <c:ptCount val="4"/>
                  <c:pt idx="0">
                    <c:v>0.21650843652155419</c:v>
                  </c:pt>
                  <c:pt idx="1">
                    <c:v>0.49140644331412486</c:v>
                  </c:pt>
                  <c:pt idx="2">
                    <c:v>0.13249432538289074</c:v>
                  </c:pt>
                  <c:pt idx="3">
                    <c:v>0.42486241561130733</c:v>
                  </c:pt>
                </c:numCache>
              </c:numRef>
            </c:plus>
            <c:minus>
              <c:numRef>
                <c:f>Sheet1!$C$45:$F$45</c:f>
                <c:numCache>
                  <c:formatCode>General</c:formatCode>
                  <c:ptCount val="4"/>
                  <c:pt idx="0">
                    <c:v>0.21650843652155419</c:v>
                  </c:pt>
                  <c:pt idx="1">
                    <c:v>0.49140644331412486</c:v>
                  </c:pt>
                  <c:pt idx="2">
                    <c:v>0.13249432538289074</c:v>
                  </c:pt>
                  <c:pt idx="3">
                    <c:v>0.424862415611307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41:$F$41</c:f>
              <c:strCache>
                <c:ptCount val="4"/>
                <c:pt idx="0">
                  <c:v>DBY746</c:v>
                </c:pt>
                <c:pt idx="1">
                  <c:v>sir2∆</c:v>
                </c:pt>
                <c:pt idx="2">
                  <c:v>tor1∆</c:v>
                </c:pt>
                <c:pt idx="3">
                  <c:v>sir2∆tor1∆</c:v>
                </c:pt>
              </c:strCache>
            </c:strRef>
          </c:cat>
          <c:val>
            <c:numRef>
              <c:f>Sheet1!$C$42:$F$42</c:f>
              <c:numCache>
                <c:formatCode>0.0</c:formatCode>
                <c:ptCount val="4"/>
                <c:pt idx="0">
                  <c:v>0.99735502385237629</c:v>
                </c:pt>
                <c:pt idx="1">
                  <c:v>2.4068265454365005</c:v>
                </c:pt>
                <c:pt idx="2">
                  <c:v>0.58998764920363611</c:v>
                </c:pt>
                <c:pt idx="3">
                  <c:v>1.74540288739759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15D-46E0-B07F-A467DD52D1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397831840"/>
        <c:axId val="397832232"/>
      </c:barChart>
      <c:catAx>
        <c:axId val="3978318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97832232"/>
        <c:crosses val="autoZero"/>
        <c:auto val="1"/>
        <c:lblAlgn val="ctr"/>
        <c:lblOffset val="100"/>
        <c:noMultiLvlLbl val="0"/>
      </c:catAx>
      <c:valAx>
        <c:axId val="39783223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2.5570833333333334E-2"/>
              <c:y val="9.47901234567901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.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97831840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</a:t>
            </a:r>
          </a:p>
        </c:rich>
      </c:tx>
      <c:layout>
        <c:manualLayout>
          <c:xMode val="edge"/>
          <c:yMode val="edge"/>
          <c:x val="0.35318194444444451"/>
          <c:y val="7.098765432098765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35065277777777776"/>
          <c:y val="0.13413190146028403"/>
          <c:w val="0.61106111111111117"/>
          <c:h val="0.633362345679012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E72-493E-9986-D00872ADB807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E72-493E-9986-D00872ADB807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E72-493E-9986-D00872ADB807}"/>
              </c:ext>
            </c:extLst>
          </c:dPt>
          <c:errBars>
            <c:errBarType val="plus"/>
            <c:errValType val="cust"/>
            <c:noEndCap val="0"/>
            <c:plus>
              <c:numRef>
                <c:f>graph!$C$14:$F$14</c:f>
                <c:numCache>
                  <c:formatCode>General</c:formatCode>
                  <c:ptCount val="4"/>
                  <c:pt idx="0">
                    <c:v>4.1707788770714509E-2</c:v>
                  </c:pt>
                  <c:pt idx="1">
                    <c:v>4.9540852719736107E-2</c:v>
                  </c:pt>
                  <c:pt idx="2">
                    <c:v>6.1455136989133879E-2</c:v>
                  </c:pt>
                  <c:pt idx="3">
                    <c:v>6.2788264637317237E-2</c:v>
                  </c:pt>
                </c:numCache>
              </c:numRef>
            </c:plus>
            <c:minus>
              <c:numRef>
                <c:f>graph!$C$14:$F$14</c:f>
                <c:numCache>
                  <c:formatCode>General</c:formatCode>
                  <c:ptCount val="4"/>
                  <c:pt idx="0">
                    <c:v>4.1707788770714509E-2</c:v>
                  </c:pt>
                  <c:pt idx="1">
                    <c:v>4.9540852719736107E-2</c:v>
                  </c:pt>
                  <c:pt idx="2">
                    <c:v>6.1455136989133879E-2</c:v>
                  </c:pt>
                  <c:pt idx="3">
                    <c:v>6.278826463731723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aph!$C$12:$F$12</c:f>
              <c:strCache>
                <c:ptCount val="4"/>
                <c:pt idx="0">
                  <c:v>WT</c:v>
                </c:pt>
                <c:pt idx="1">
                  <c:v>pib2∆</c:v>
                </c:pt>
                <c:pt idx="2">
                  <c:v>tor1∆</c:v>
                </c:pt>
                <c:pt idx="3">
                  <c:v>gtr1∆</c:v>
                </c:pt>
              </c:strCache>
            </c:strRef>
          </c:cat>
          <c:val>
            <c:numRef>
              <c:f>graph!$C$13:$F$13</c:f>
              <c:numCache>
                <c:formatCode>0.00</c:formatCode>
                <c:ptCount val="4"/>
                <c:pt idx="0">
                  <c:v>1.0153099398964853</c:v>
                </c:pt>
                <c:pt idx="1">
                  <c:v>0.99705989536540862</c:v>
                </c:pt>
                <c:pt idx="2">
                  <c:v>0.46431797454037116</c:v>
                </c:pt>
                <c:pt idx="3">
                  <c:v>0.454002571284675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E72-493E-9986-D00872ADB8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117248223"/>
        <c:axId val="117252799"/>
      </c:barChart>
      <c:catAx>
        <c:axId val="1172482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17252799"/>
        <c:crosses val="autoZero"/>
        <c:auto val="1"/>
        <c:lblAlgn val="ctr"/>
        <c:lblOffset val="100"/>
        <c:noMultiLvlLbl val="0"/>
      </c:catAx>
      <c:valAx>
        <c:axId val="117252799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  <a:endPara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7804861111111109E-2"/>
              <c:y val="0.134228395061728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17248223"/>
        <c:crosses val="autoZero"/>
        <c:crossBetween val="between"/>
        <c:majorUnit val="0.5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1000">
                <a:solidFill>
                  <a:schemeClr val="tx1"/>
                </a:solidFill>
              </a:rPr>
              <a:t>SEP</a:t>
            </a:r>
            <a:r>
              <a:rPr lang="en-US" altLang="ko-KR" sz="1000" baseline="0">
                <a:solidFill>
                  <a:schemeClr val="tx1"/>
                </a:solidFill>
              </a:rPr>
              <a:t> Standard curve</a:t>
            </a:r>
            <a:endParaRPr lang="ko-KR" altLang="en-US" sz="100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38446527777777767"/>
          <c:y val="5.732638888888889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ko-KR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ysClr val="windowText" lastClr="000000"/>
              </a:solidFill>
              <a:ln w="12700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poly"/>
            <c:order val="3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SEP!$L$72:$L$79</c:f>
                <c:numCache>
                  <c:formatCode>General</c:formatCode>
                  <c:ptCount val="8"/>
                  <c:pt idx="0">
                    <c:v>2.1384458297246103</c:v>
                  </c:pt>
                  <c:pt idx="1">
                    <c:v>0.54525223520862409</c:v>
                  </c:pt>
                  <c:pt idx="2">
                    <c:v>1.7922907586762713</c:v>
                  </c:pt>
                  <c:pt idx="3">
                    <c:v>4.6836468664596138</c:v>
                  </c:pt>
                  <c:pt idx="4">
                    <c:v>5.5639768941637371</c:v>
                  </c:pt>
                  <c:pt idx="5">
                    <c:v>3.2520091579877795</c:v>
                  </c:pt>
                  <c:pt idx="6">
                    <c:v>5.7513104349962676</c:v>
                  </c:pt>
                  <c:pt idx="7">
                    <c:v>4.9638364841027034</c:v>
                  </c:pt>
                </c:numCache>
              </c:numRef>
            </c:plus>
            <c:minus>
              <c:numRef>
                <c:f>SEP!$L$72:$L$79</c:f>
                <c:numCache>
                  <c:formatCode>General</c:formatCode>
                  <c:ptCount val="8"/>
                  <c:pt idx="0">
                    <c:v>2.1384458297246103</c:v>
                  </c:pt>
                  <c:pt idx="1">
                    <c:v>0.54525223520862409</c:v>
                  </c:pt>
                  <c:pt idx="2">
                    <c:v>1.7922907586762713</c:v>
                  </c:pt>
                  <c:pt idx="3">
                    <c:v>4.6836468664596138</c:v>
                  </c:pt>
                  <c:pt idx="4">
                    <c:v>5.5639768941637371</c:v>
                  </c:pt>
                  <c:pt idx="5">
                    <c:v>3.2520091579877795</c:v>
                  </c:pt>
                  <c:pt idx="6">
                    <c:v>5.7513104349962676</c:v>
                  </c:pt>
                  <c:pt idx="7">
                    <c:v>4.96383648410270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EP!$J$72:$J$79</c:f>
              <c:numCache>
                <c:formatCode>General</c:formatCode>
                <c:ptCount val="8"/>
                <c:pt idx="0">
                  <c:v>5</c:v>
                </c:pt>
                <c:pt idx="1">
                  <c:v>5.5</c:v>
                </c:pt>
                <c:pt idx="2">
                  <c:v>6</c:v>
                </c:pt>
                <c:pt idx="3">
                  <c:v>6.5</c:v>
                </c:pt>
                <c:pt idx="4">
                  <c:v>7</c:v>
                </c:pt>
                <c:pt idx="5">
                  <c:v>7.5</c:v>
                </c:pt>
                <c:pt idx="6">
                  <c:v>8</c:v>
                </c:pt>
                <c:pt idx="7">
                  <c:v>8.5</c:v>
                </c:pt>
              </c:numCache>
            </c:numRef>
          </c:xVal>
          <c:yVal>
            <c:numRef>
              <c:f>SEP!$K$72:$K$79</c:f>
              <c:numCache>
                <c:formatCode>General</c:formatCode>
                <c:ptCount val="8"/>
                <c:pt idx="0">
                  <c:v>15.380370370370374</c:v>
                </c:pt>
                <c:pt idx="1">
                  <c:v>17.62</c:v>
                </c:pt>
                <c:pt idx="2">
                  <c:v>22.678846153846152</c:v>
                </c:pt>
                <c:pt idx="3">
                  <c:v>32.957413793103456</c:v>
                </c:pt>
                <c:pt idx="4">
                  <c:v>48.036833333333341</c:v>
                </c:pt>
                <c:pt idx="5">
                  <c:v>59.385818181818188</c:v>
                </c:pt>
                <c:pt idx="6">
                  <c:v>61.518070175438559</c:v>
                </c:pt>
                <c:pt idx="7">
                  <c:v>65.1163934426230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2B5-4FD8-AAE9-10C9FD958F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3769656"/>
        <c:axId val="293770640"/>
      </c:scatterChart>
      <c:valAx>
        <c:axId val="293769656"/>
        <c:scaling>
          <c:orientation val="minMax"/>
          <c:max val="9"/>
          <c:min val="4.5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toplasmic pH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93770640"/>
        <c:crosses val="autoZero"/>
        <c:crossBetween val="midCat"/>
        <c:majorUnit val="0.5"/>
      </c:valAx>
      <c:valAx>
        <c:axId val="2937706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uorescence intensity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93769656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1412430555555557"/>
          <c:y val="7.0555555555555552E-2"/>
          <c:w val="0.53774583333333337"/>
          <c:h val="0.626709259259259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E42-4D16-80A5-A5B3838A4FDC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E42-4D16-80A5-A5B3838A4FDC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FE42-4D16-80A5-A5B3838A4FDC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FE42-4D16-80A5-A5B3838A4FDC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B$13:$E$13</c:f>
                <c:numCache>
                  <c:formatCode>General</c:formatCode>
                  <c:ptCount val="4"/>
                  <c:pt idx="0">
                    <c:v>1.0388692556849659</c:v>
                  </c:pt>
                  <c:pt idx="1">
                    <c:v>8.2126223134326035E-2</c:v>
                  </c:pt>
                  <c:pt idx="2">
                    <c:v>6.975612067780057</c:v>
                  </c:pt>
                  <c:pt idx="3">
                    <c:v>5.7500990997587387</c:v>
                  </c:pt>
                </c:numCache>
              </c:numRef>
            </c:plus>
            <c:minus>
              <c:numRef>
                <c:f>Sheet2!$B$13:$E$13</c:f>
                <c:numCache>
                  <c:formatCode>General</c:formatCode>
                  <c:ptCount val="4"/>
                  <c:pt idx="0">
                    <c:v>1.0388692556849659</c:v>
                  </c:pt>
                  <c:pt idx="1">
                    <c:v>8.2126223134326035E-2</c:v>
                  </c:pt>
                  <c:pt idx="2">
                    <c:v>6.975612067780057</c:v>
                  </c:pt>
                  <c:pt idx="3">
                    <c:v>5.75009909975873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7:$E$7</c:f>
              <c:strCache>
                <c:ptCount val="4"/>
                <c:pt idx="0">
                  <c:v>WT</c:v>
                </c:pt>
                <c:pt idx="1">
                  <c:v>sir2∆</c:v>
                </c:pt>
                <c:pt idx="2">
                  <c:v>tor1∆</c:v>
                </c:pt>
                <c:pt idx="3">
                  <c:v>tor1∆sir2∆</c:v>
                </c:pt>
              </c:strCache>
            </c:strRef>
          </c:cat>
          <c:val>
            <c:numRef>
              <c:f>Sheet2!$B$9:$E$9</c:f>
              <c:numCache>
                <c:formatCode>0.0</c:formatCode>
                <c:ptCount val="4"/>
                <c:pt idx="0">
                  <c:v>34.430243669374107</c:v>
                </c:pt>
                <c:pt idx="1">
                  <c:v>4.8199767711962833</c:v>
                </c:pt>
                <c:pt idx="2">
                  <c:v>60.48805815160955</c:v>
                </c:pt>
                <c:pt idx="3">
                  <c:v>10.2197802197802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E42-4D16-80A5-A5B3838A4F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1884177840"/>
        <c:axId val="1884174928"/>
      </c:barChart>
      <c:catAx>
        <c:axId val="1884177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884174928"/>
        <c:crosses val="autoZero"/>
        <c:auto val="1"/>
        <c:lblAlgn val="ctr"/>
        <c:lblOffset val="100"/>
        <c:noMultiLvlLbl val="0"/>
      </c:catAx>
      <c:valAx>
        <c:axId val="1884174928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</a:t>
                </a:r>
                <a:r>
                  <a:rPr lang="en-US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 buds 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ith high vacuole acidity</a:t>
                </a:r>
                <a:endParaRPr 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5277777777777776E-2"/>
              <c:y val="7.839506172839506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884177840"/>
        <c:crosses val="autoZero"/>
        <c:crossBetween val="between"/>
        <c:majorUnit val="20"/>
        <c:minorUnit val="1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1412430555555557"/>
          <c:y val="4.7037037037037037E-2"/>
          <c:w val="0.53231458333333337"/>
          <c:h val="0.62529814814814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204-4944-8CAC-227B7A72EC34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204-4944-8CAC-227B7A72EC3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204-4944-8CAC-227B7A72EC34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B$12:$E$12</c:f>
                <c:numCache>
                  <c:formatCode>General</c:formatCode>
                  <c:ptCount val="4"/>
                  <c:pt idx="0">
                    <c:v>0.86994742549228876</c:v>
                  </c:pt>
                  <c:pt idx="1">
                    <c:v>2.2447834323382461</c:v>
                  </c:pt>
                  <c:pt idx="2">
                    <c:v>2.4475831816772144</c:v>
                  </c:pt>
                  <c:pt idx="3">
                    <c:v>2.4773876884493138</c:v>
                  </c:pt>
                </c:numCache>
              </c:numRef>
            </c:plus>
            <c:minus>
              <c:numRef>
                <c:f>Sheet2!$B$12:$E$12</c:f>
                <c:numCache>
                  <c:formatCode>General</c:formatCode>
                  <c:ptCount val="4"/>
                  <c:pt idx="0">
                    <c:v>0.86994742549228876</c:v>
                  </c:pt>
                  <c:pt idx="1">
                    <c:v>2.2447834323382461</c:v>
                  </c:pt>
                  <c:pt idx="2">
                    <c:v>2.4475831816772144</c:v>
                  </c:pt>
                  <c:pt idx="3">
                    <c:v>2.47738768844931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7:$E$7</c:f>
              <c:strCache>
                <c:ptCount val="4"/>
                <c:pt idx="0">
                  <c:v>WT</c:v>
                </c:pt>
                <c:pt idx="1">
                  <c:v>sir2∆</c:v>
                </c:pt>
                <c:pt idx="2">
                  <c:v>tor1∆</c:v>
                </c:pt>
                <c:pt idx="3">
                  <c:v>tor1∆sir2∆</c:v>
                </c:pt>
              </c:strCache>
            </c:strRef>
          </c:cat>
          <c:val>
            <c:numRef>
              <c:f>Sheet2!$B$8:$E$8</c:f>
              <c:numCache>
                <c:formatCode>0.0</c:formatCode>
                <c:ptCount val="4"/>
                <c:pt idx="0">
                  <c:v>12.571667462971812</c:v>
                </c:pt>
                <c:pt idx="1">
                  <c:v>1.5873015873015872</c:v>
                </c:pt>
                <c:pt idx="2">
                  <c:v>27.898926964347524</c:v>
                </c:pt>
                <c:pt idx="3">
                  <c:v>3.29023917259211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204-4944-8CAC-227B7A72EC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1884177840"/>
        <c:axId val="1884174928"/>
      </c:barChart>
      <c:catAx>
        <c:axId val="1884177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884174928"/>
        <c:crosses val="autoZero"/>
        <c:auto val="1"/>
        <c:lblAlgn val="ctr"/>
        <c:lblOffset val="100"/>
        <c:noMultiLvlLbl val="0"/>
      </c:catAx>
      <c:valAx>
        <c:axId val="1884174928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of mother cells with high vacuole acidity</a:t>
                </a:r>
                <a:endParaRPr lang="ko-KR" sz="8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7638888888888888E-2"/>
              <c:y val="3.135802469135802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884177840"/>
        <c:crosses val="autoZero"/>
        <c:crossBetween val="between"/>
        <c:majorUnit val="20"/>
        <c:minorUnit val="1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3370347222222216"/>
          <c:y val="6.2716049382716049E-2"/>
          <c:w val="0.51337986111111111"/>
          <c:h val="0.592696296296296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53D-42AA-8B6A-13497992690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53D-42AA-8B6A-13497992690A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53D-42AA-8B6A-13497992690A}"/>
              </c:ext>
            </c:extLst>
          </c:dPt>
          <c:dPt>
            <c:idx val="3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153D-42AA-8B6A-13497992690A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C$9:$F$9</c:f>
                <c:numCache>
                  <c:formatCode>General</c:formatCode>
                  <c:ptCount val="4"/>
                  <c:pt idx="0">
                    <c:v>0.46271962928748345</c:v>
                  </c:pt>
                  <c:pt idx="1">
                    <c:v>1.0101525445522108</c:v>
                  </c:pt>
                  <c:pt idx="2">
                    <c:v>1.0699293617953798</c:v>
                  </c:pt>
                  <c:pt idx="3">
                    <c:v>0.18916714317457106</c:v>
                  </c:pt>
                </c:numCache>
              </c:numRef>
            </c:plus>
            <c:minus>
              <c:numRef>
                <c:f>Sheet2!$C$9:$F$9</c:f>
                <c:numCache>
                  <c:formatCode>General</c:formatCode>
                  <c:ptCount val="4"/>
                  <c:pt idx="0">
                    <c:v>0.46271962928748345</c:v>
                  </c:pt>
                  <c:pt idx="1">
                    <c:v>1.0101525445522108</c:v>
                  </c:pt>
                  <c:pt idx="2">
                    <c:v>1.0699293617953798</c:v>
                  </c:pt>
                  <c:pt idx="3">
                    <c:v>0.189167143174571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C$4:$F$4</c:f>
              <c:strCache>
                <c:ptCount val="4"/>
                <c:pt idx="0">
                  <c:v>WT</c:v>
                </c:pt>
                <c:pt idx="1">
                  <c:v>sir2∆</c:v>
                </c:pt>
                <c:pt idx="2">
                  <c:v>kns1∆Sir2-A</c:v>
                </c:pt>
                <c:pt idx="3">
                  <c:v>kns1Sir2-E</c:v>
                </c:pt>
              </c:strCache>
            </c:strRef>
          </c:cat>
          <c:val>
            <c:numRef>
              <c:f>Sheet2!$C$5:$F$5</c:f>
              <c:numCache>
                <c:formatCode>0.0</c:formatCode>
                <c:ptCount val="4"/>
                <c:pt idx="0">
                  <c:v>23.703815564280681</c:v>
                </c:pt>
                <c:pt idx="1">
                  <c:v>0.7142857142857143</c:v>
                </c:pt>
                <c:pt idx="2">
                  <c:v>55.423220973782776</c:v>
                </c:pt>
                <c:pt idx="3">
                  <c:v>4.62814339218833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53D-42AA-8B6A-1349799269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1234872112"/>
        <c:axId val="1234874192"/>
      </c:barChart>
      <c:catAx>
        <c:axId val="1234872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234874192"/>
        <c:crosses val="autoZero"/>
        <c:auto val="1"/>
        <c:lblAlgn val="ctr"/>
        <c:lblOffset val="100"/>
        <c:noMultiLvlLbl val="0"/>
      </c:catAx>
      <c:valAx>
        <c:axId val="1234874192"/>
        <c:scaling>
          <c:orientation val="minMax"/>
          <c:max val="14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of mother cells with high vacuolar acidity</a:t>
                </a:r>
              </a:p>
            </c:rich>
          </c:tx>
          <c:layout>
            <c:manualLayout>
              <c:xMode val="edge"/>
              <c:yMode val="edge"/>
              <c:x val="5.2916666666666667E-2"/>
              <c:y val="2.351851851851851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234872112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</a:t>
            </a:r>
          </a:p>
        </c:rich>
      </c:tx>
      <c:layout>
        <c:manualLayout>
          <c:xMode val="edge"/>
          <c:yMode val="edge"/>
          <c:x val="0.36383859751609049"/>
          <c:y val="2.123456790123456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3504476436199167"/>
          <c:y val="0.11367283950617284"/>
          <c:w val="0.59624522225811827"/>
          <c:h val="0.638816666666666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$27</c:f>
              <c:strCache>
                <c:ptCount val="1"/>
                <c:pt idx="0">
                  <c:v>PMA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48E-4109-ABED-5248E07A5469}"/>
              </c:ext>
            </c:extLst>
          </c:dPt>
          <c:dPt>
            <c:idx val="1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48E-4109-ABED-5248E07A5469}"/>
              </c:ext>
            </c:extLst>
          </c:dPt>
          <c:dPt>
            <c:idx val="2"/>
            <c:invertIfNegative val="0"/>
            <c:bubble3D val="0"/>
            <c:spPr>
              <a:pattFill prst="lt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48E-4109-ABED-5248E07A5469}"/>
              </c:ext>
            </c:extLst>
          </c:dPt>
          <c:dPt>
            <c:idx val="3"/>
            <c:invertIfNegative val="0"/>
            <c:bubble3D val="0"/>
            <c:spPr>
              <a:pattFill prst="pct75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48E-4109-ABED-5248E07A5469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B$32:$E$32</c:f>
                <c:numCache>
                  <c:formatCode>General</c:formatCode>
                  <c:ptCount val="4"/>
                  <c:pt idx="0">
                    <c:v>2.2546673588766188E-2</c:v>
                  </c:pt>
                  <c:pt idx="1">
                    <c:v>0.12530451550023708</c:v>
                  </c:pt>
                  <c:pt idx="2">
                    <c:v>2.7039530597643906E-2</c:v>
                  </c:pt>
                  <c:pt idx="3">
                    <c:v>1.5468325115639885E-2</c:v>
                  </c:pt>
                </c:numCache>
              </c:numRef>
            </c:plus>
            <c:minus>
              <c:numRef>
                <c:f>Sheet2!$B$32:$E$32</c:f>
                <c:numCache>
                  <c:formatCode>General</c:formatCode>
                  <c:ptCount val="4"/>
                  <c:pt idx="0">
                    <c:v>2.2546673588766188E-2</c:v>
                  </c:pt>
                  <c:pt idx="1">
                    <c:v>0.12530451550023708</c:v>
                  </c:pt>
                  <c:pt idx="2">
                    <c:v>2.7039530597643906E-2</c:v>
                  </c:pt>
                  <c:pt idx="3">
                    <c:v>1.546832511563988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26:$D$26</c:f>
              <c:strCache>
                <c:ptCount val="3"/>
                <c:pt idx="0">
                  <c:v>WT</c:v>
                </c:pt>
                <c:pt idx="1">
                  <c:v>sir2Δ</c:v>
                </c:pt>
                <c:pt idx="2">
                  <c:v>sch9Δ</c:v>
                </c:pt>
              </c:strCache>
            </c:strRef>
          </c:cat>
          <c:val>
            <c:numRef>
              <c:f>Sheet2!$B$27:$D$27</c:f>
              <c:numCache>
                <c:formatCode>0.00</c:formatCode>
                <c:ptCount val="3"/>
                <c:pt idx="0">
                  <c:v>0.99605743788364209</c:v>
                </c:pt>
                <c:pt idx="1">
                  <c:v>1.6795298231050835</c:v>
                </c:pt>
                <c:pt idx="2">
                  <c:v>0.925224585537341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48E-4109-ABED-5248E07A54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491234656"/>
        <c:axId val="491230736"/>
      </c:barChart>
      <c:catAx>
        <c:axId val="4912346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91230736"/>
        <c:crosses val="autoZero"/>
        <c:auto val="1"/>
        <c:lblAlgn val="ctr"/>
        <c:lblOffset val="100"/>
        <c:noMultiLvlLbl val="0"/>
      </c:catAx>
      <c:valAx>
        <c:axId val="491230736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1.4497916666666671E-2"/>
              <c:y val="0.159662345679012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91234656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</a:t>
            </a:r>
          </a:p>
        </c:rich>
      </c:tx>
      <c:layout>
        <c:manualLayout>
          <c:xMode val="edge"/>
          <c:yMode val="edge"/>
          <c:x val="0.36200138888888889"/>
          <c:y val="6.9129629629629619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35554305555555554"/>
          <c:y val="0.11371038281113459"/>
          <c:w val="0.59230972222222222"/>
          <c:h val="0.5480567901234567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0B8-43CC-AC87-1CC6F77C2FD0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0B8-43CC-AC87-1CC6F77C2FD0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0B8-43CC-AC87-1CC6F77C2FD0}"/>
              </c:ext>
            </c:extLst>
          </c:dPt>
          <c:errBars>
            <c:errBarType val="plus"/>
            <c:errValType val="cust"/>
            <c:noEndCap val="0"/>
            <c:plus>
              <c:numRef>
                <c:f>Sheet3!$C$44:$F$44</c:f>
                <c:numCache>
                  <c:formatCode>General</c:formatCode>
                  <c:ptCount val="4"/>
                  <c:pt idx="0">
                    <c:v>0.12242002276049503</c:v>
                  </c:pt>
                  <c:pt idx="1">
                    <c:v>0.31127809523558658</c:v>
                  </c:pt>
                  <c:pt idx="2">
                    <c:v>9.1825443361866266E-2</c:v>
                  </c:pt>
                  <c:pt idx="3">
                    <c:v>6.8170266249573355E-2</c:v>
                  </c:pt>
                </c:numCache>
              </c:numRef>
            </c:plus>
            <c:minus>
              <c:numRef>
                <c:f>Sheet3!$C$44:$F$44</c:f>
                <c:numCache>
                  <c:formatCode>General</c:formatCode>
                  <c:ptCount val="4"/>
                  <c:pt idx="0">
                    <c:v>0.12242002276049503</c:v>
                  </c:pt>
                  <c:pt idx="1">
                    <c:v>0.31127809523558658</c:v>
                  </c:pt>
                  <c:pt idx="2">
                    <c:v>9.1825443361866266E-2</c:v>
                  </c:pt>
                  <c:pt idx="3">
                    <c:v>6.817026624957335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C$40:$F$40</c:f>
              <c:strCache>
                <c:ptCount val="4"/>
                <c:pt idx="0">
                  <c:v>WT</c:v>
                </c:pt>
                <c:pt idx="1">
                  <c:v>pde2∆</c:v>
                </c:pt>
                <c:pt idx="2">
                  <c:v>tor1∆</c:v>
                </c:pt>
                <c:pt idx="3">
                  <c:v>pde2∆tor1∆</c:v>
                </c:pt>
              </c:strCache>
            </c:strRef>
          </c:cat>
          <c:val>
            <c:numRef>
              <c:f>Sheet3!$C$41:$F$41</c:f>
              <c:numCache>
                <c:formatCode>0.00</c:formatCode>
                <c:ptCount val="4"/>
                <c:pt idx="0">
                  <c:v>0.99888142649986023</c:v>
                </c:pt>
                <c:pt idx="1">
                  <c:v>1.5445510113151524</c:v>
                </c:pt>
                <c:pt idx="2">
                  <c:v>0.7330537529495067</c:v>
                </c:pt>
                <c:pt idx="3">
                  <c:v>0.929531740458410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0B8-43CC-AC87-1CC6F77C2F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450545688"/>
        <c:axId val="450543336"/>
      </c:barChart>
      <c:catAx>
        <c:axId val="450545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50543336"/>
        <c:crosses val="autoZero"/>
        <c:auto val="1"/>
        <c:lblAlgn val="ctr"/>
        <c:lblOffset val="100"/>
        <c:noMultiLvlLbl val="0"/>
      </c:catAx>
      <c:valAx>
        <c:axId val="450543336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.0_);[Red]\(0.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50545688"/>
        <c:crosses val="autoZero"/>
        <c:crossBetween val="between"/>
        <c:majorUnit val="0.5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9938</cdr:x>
      <cdr:y>0.26856</cdr:y>
    </cdr:from>
    <cdr:to>
      <cdr:x>0.56881</cdr:x>
      <cdr:y>0.36301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575107" y="435064"/>
          <a:ext cx="243979" cy="1530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800" dirty="0">
              <a:latin typeface="Times New Roman" panose="02020603050405020304" pitchFamily="18" charset="0"/>
              <a:cs typeface="Times New Roman" panose="02020603050405020304" pitchFamily="18" charset="0"/>
            </a:rPr>
            <a:t>N.S.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AF971-584F-45CF-BB7D-3A0B44A96584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6800" y="1143000"/>
            <a:ext cx="2184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E790C7-1131-43EE-8DC8-9E47647BD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367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E790C7-1131-43EE-8DC8-9E47647BDFFE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4504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414125"/>
            <a:ext cx="5201841" cy="300826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538401"/>
            <a:ext cx="4589860" cy="2086184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953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303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60041"/>
            <a:ext cx="1319585" cy="732264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60041"/>
            <a:ext cx="3882256" cy="732264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452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932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154193"/>
            <a:ext cx="5278339" cy="3594317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782513"/>
            <a:ext cx="5278339" cy="1890166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80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300203"/>
            <a:ext cx="2600921" cy="548248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300203"/>
            <a:ext cx="2600921" cy="548248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292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60043"/>
            <a:ext cx="5278339" cy="167014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118188"/>
            <a:ext cx="2588967" cy="103809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156278"/>
            <a:ext cx="2588967" cy="464241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118188"/>
            <a:ext cx="2601718" cy="1038091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156278"/>
            <a:ext cx="2601718" cy="464241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076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086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458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76051"/>
            <a:ext cx="1973799" cy="201617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244112"/>
            <a:ext cx="3098155" cy="6140542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592229"/>
            <a:ext cx="1973799" cy="480242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628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76051"/>
            <a:ext cx="1973799" cy="201617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244112"/>
            <a:ext cx="3098155" cy="6140542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592229"/>
            <a:ext cx="1973799" cy="480242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650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60043"/>
            <a:ext cx="5278339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300203"/>
            <a:ext cx="5278339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8008709"/>
            <a:ext cx="137695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AB2E05-4057-4B1F-BE7F-1BE3B7518E23}" type="datetimeFigureOut">
              <a:rPr lang="en-US" smtClean="0"/>
              <a:t>3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8008709"/>
            <a:ext cx="2065437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8008709"/>
            <a:ext cx="137695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63256-F3F2-4C04-A82B-9FE6D631F1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245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chart" Target="../charts/chart2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6.png"/><Relationship Id="rId18" Type="http://schemas.openxmlformats.org/officeDocument/2006/relationships/image" Target="../media/image21.png"/><Relationship Id="rId26" Type="http://schemas.openxmlformats.org/officeDocument/2006/relationships/image" Target="../media/image29.png"/><Relationship Id="rId3" Type="http://schemas.openxmlformats.org/officeDocument/2006/relationships/image" Target="../media/image6.png"/><Relationship Id="rId21" Type="http://schemas.openxmlformats.org/officeDocument/2006/relationships/image" Target="../media/image24.png"/><Relationship Id="rId34" Type="http://schemas.openxmlformats.org/officeDocument/2006/relationships/chart" Target="../charts/chart5.xml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17" Type="http://schemas.openxmlformats.org/officeDocument/2006/relationships/image" Target="../media/image20.png"/><Relationship Id="rId25" Type="http://schemas.openxmlformats.org/officeDocument/2006/relationships/image" Target="../media/image28.png"/><Relationship Id="rId33" Type="http://schemas.openxmlformats.org/officeDocument/2006/relationships/image" Target="../media/image36.png"/><Relationship Id="rId2" Type="http://schemas.openxmlformats.org/officeDocument/2006/relationships/image" Target="../media/image5.png"/><Relationship Id="rId16" Type="http://schemas.openxmlformats.org/officeDocument/2006/relationships/image" Target="../media/image19.png"/><Relationship Id="rId20" Type="http://schemas.openxmlformats.org/officeDocument/2006/relationships/image" Target="../media/image23.png"/><Relationship Id="rId29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24" Type="http://schemas.openxmlformats.org/officeDocument/2006/relationships/image" Target="../media/image27.png"/><Relationship Id="rId32" Type="http://schemas.openxmlformats.org/officeDocument/2006/relationships/image" Target="../media/image35.png"/><Relationship Id="rId5" Type="http://schemas.openxmlformats.org/officeDocument/2006/relationships/image" Target="../media/image8.png"/><Relationship Id="rId15" Type="http://schemas.openxmlformats.org/officeDocument/2006/relationships/image" Target="../media/image18.png"/><Relationship Id="rId23" Type="http://schemas.openxmlformats.org/officeDocument/2006/relationships/image" Target="../media/image26.png"/><Relationship Id="rId28" Type="http://schemas.openxmlformats.org/officeDocument/2006/relationships/image" Target="../media/image31.png"/><Relationship Id="rId10" Type="http://schemas.openxmlformats.org/officeDocument/2006/relationships/image" Target="../media/image13.png"/><Relationship Id="rId19" Type="http://schemas.openxmlformats.org/officeDocument/2006/relationships/image" Target="../media/image22.png"/><Relationship Id="rId31" Type="http://schemas.openxmlformats.org/officeDocument/2006/relationships/image" Target="../media/image34.png"/><Relationship Id="rId4" Type="http://schemas.openxmlformats.org/officeDocument/2006/relationships/image" Target="../media/image7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Relationship Id="rId22" Type="http://schemas.openxmlformats.org/officeDocument/2006/relationships/image" Target="../media/image25.png"/><Relationship Id="rId27" Type="http://schemas.openxmlformats.org/officeDocument/2006/relationships/image" Target="../media/image30.png"/><Relationship Id="rId30" Type="http://schemas.openxmlformats.org/officeDocument/2006/relationships/image" Target="../media/image33.png"/><Relationship Id="rId35" Type="http://schemas.openxmlformats.org/officeDocument/2006/relationships/chart" Target="../charts/chart6.xml"/><Relationship Id="rId8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13" Type="http://schemas.openxmlformats.org/officeDocument/2006/relationships/chart" Target="../charts/chart7.xml"/><Relationship Id="rId3" Type="http://schemas.openxmlformats.org/officeDocument/2006/relationships/image" Target="../media/image38.png"/><Relationship Id="rId7" Type="http://schemas.openxmlformats.org/officeDocument/2006/relationships/image" Target="../media/image41.png"/><Relationship Id="rId12" Type="http://schemas.openxmlformats.org/officeDocument/2006/relationships/image" Target="../media/image46.pn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11" Type="http://schemas.openxmlformats.org/officeDocument/2006/relationships/image" Target="../media/image45.png"/><Relationship Id="rId5" Type="http://schemas.openxmlformats.org/officeDocument/2006/relationships/image" Target="../media/image39.png"/><Relationship Id="rId10" Type="http://schemas.openxmlformats.org/officeDocument/2006/relationships/image" Target="../media/image44.png"/><Relationship Id="rId4" Type="http://schemas.microsoft.com/office/2007/relationships/hdphoto" Target="../media/hdphoto3.wdp"/><Relationship Id="rId9" Type="http://schemas.openxmlformats.org/officeDocument/2006/relationships/image" Target="../media/image43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9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1405563" y="488550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520362" y="2241515"/>
            <a:ext cx="2216043" cy="997633"/>
            <a:chOff x="431534" y="3720288"/>
            <a:chExt cx="2216043" cy="997633"/>
          </a:xfrm>
        </p:grpSpPr>
        <p:grpSp>
          <p:nvGrpSpPr>
            <p:cNvPr id="4" name="Group 3"/>
            <p:cNvGrpSpPr/>
            <p:nvPr/>
          </p:nvGrpSpPr>
          <p:grpSpPr>
            <a:xfrm>
              <a:off x="431534" y="3804969"/>
              <a:ext cx="2216043" cy="912952"/>
              <a:chOff x="2220862" y="1951380"/>
              <a:chExt cx="2954722" cy="1217269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2220862" y="2562976"/>
                <a:ext cx="964366" cy="4154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ct val="150000"/>
                  </a:lnSpc>
                </a:pPr>
                <a:r>
                  <a:rPr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2</a:t>
                </a:r>
                <a:r>
                  <a:rPr lang="el-GR" altLang="ko-KR" sz="9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r>
                  <a:rPr lang="en-US" altLang="ko-KR" sz="9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r1</a:t>
                </a:r>
                <a:r>
                  <a:rPr lang="el-GR" altLang="ko-KR" sz="9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endParaRPr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3321499" y="2850613"/>
                <a:ext cx="1750907" cy="3180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PD          </a:t>
                </a:r>
                <a:r>
                  <a:rPr lang="en-US" altLang="ko-KR" sz="9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 </a:t>
                </a:r>
                <a:r>
                  <a:rPr lang="en-US" altLang="ko-KR" sz="9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 NaCl</a:t>
                </a:r>
                <a:endParaRPr lang="ko-KR" altLang="en-US" sz="9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7" name="Picture 6"/>
              <p:cNvPicPr>
                <a:picLocks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482" t="6278" r="23554" b="17454"/>
              <a:stretch/>
            </p:blipFill>
            <p:spPr>
              <a:xfrm>
                <a:off x="3118514" y="1951383"/>
                <a:ext cx="1017599" cy="9408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529" t="9170" r="20795" b="17155"/>
              <a:stretch/>
            </p:blipFill>
            <p:spPr>
              <a:xfrm>
                <a:off x="4157984" y="1951380"/>
                <a:ext cx="1017600" cy="940800"/>
              </a:xfrm>
              <a:prstGeom prst="rect">
                <a:avLst/>
              </a:prstGeom>
            </p:spPr>
          </p:pic>
        </p:grpSp>
        <p:sp>
          <p:nvSpPr>
            <p:cNvPr id="18" name="Rectangle 17"/>
            <p:cNvSpPr/>
            <p:nvPr/>
          </p:nvSpPr>
          <p:spPr>
            <a:xfrm>
              <a:off x="558172" y="3720288"/>
              <a:ext cx="596637" cy="311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BY746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692823" y="3909050"/>
              <a:ext cx="461986" cy="311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2</a:t>
              </a:r>
              <a:r>
                <a:rPr lang="el-GR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endParaRPr lang="en-US" altLang="ko-KR" sz="95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679999" y="4094324"/>
              <a:ext cx="474810" cy="311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r1</a:t>
              </a:r>
              <a:r>
                <a:rPr lang="el-GR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endParaRPr lang="en-US" altLang="ko-KR" sz="95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638045" y="427586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38045" y="1988398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812309" y="1975566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35901" y="4114819"/>
            <a:ext cx="549457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algn="just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MA1 expression through Sir2 by TORC1 signaling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a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l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menon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wild-type and sir2∆ strains were treated with (mock) or 300nM rapamycin for 1 hour and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levels were measured in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qPCR. (b)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t stress resistance was tested by spotting 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BY746,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2</a:t>
            </a:r>
            <a:r>
              <a:rPr lang="el-GR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or1</a:t>
            </a:r>
            <a:r>
              <a:rPr lang="el-GR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r2</a:t>
            </a:r>
            <a:r>
              <a:rPr lang="el-GR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r1</a:t>
            </a:r>
            <a:r>
              <a:rPr lang="el-GR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ains on YPD with or without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 M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Cl, and plates were incubated for 3 days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c)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levels were measured in indicated strains by qPCR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***p&lt;0.0001,***p&lt;0.001 ). 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964201" y="516892"/>
            <a:ext cx="1440000" cy="1620000"/>
            <a:chOff x="964201" y="516892"/>
            <a:chExt cx="1440000" cy="1620000"/>
          </a:xfrm>
        </p:grpSpPr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42806392"/>
                </p:ext>
              </p:extLst>
            </p:nvPr>
          </p:nvGraphicFramePr>
          <p:xfrm>
            <a:off x="964201" y="516892"/>
            <a:ext cx="144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pSp>
          <p:nvGrpSpPr>
            <p:cNvPr id="33" name="Group 32"/>
            <p:cNvGrpSpPr/>
            <p:nvPr/>
          </p:nvGrpSpPr>
          <p:grpSpPr>
            <a:xfrm>
              <a:off x="1528197" y="645723"/>
              <a:ext cx="692188" cy="274519"/>
              <a:chOff x="889857" y="4048166"/>
              <a:chExt cx="692188" cy="465177"/>
            </a:xfrm>
          </p:grpSpPr>
          <p:grpSp>
            <p:nvGrpSpPr>
              <p:cNvPr id="34" name="Group 33"/>
              <p:cNvGrpSpPr/>
              <p:nvPr/>
            </p:nvGrpSpPr>
            <p:grpSpPr>
              <a:xfrm>
                <a:off x="889857" y="4048166"/>
                <a:ext cx="531398" cy="421144"/>
                <a:chOff x="2149173" y="1145087"/>
                <a:chExt cx="830094" cy="730508"/>
              </a:xfrm>
            </p:grpSpPr>
            <p:cxnSp>
              <p:nvCxnSpPr>
                <p:cNvPr id="43" name="Straight Connector 42"/>
                <p:cNvCxnSpPr/>
                <p:nvPr/>
              </p:nvCxnSpPr>
              <p:spPr>
                <a:xfrm>
                  <a:off x="2149173" y="1875595"/>
                  <a:ext cx="36022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/>
                <p:cNvCxnSpPr/>
                <p:nvPr/>
              </p:nvCxnSpPr>
              <p:spPr>
                <a:xfrm>
                  <a:off x="2149173" y="1762033"/>
                  <a:ext cx="70953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2222420" y="1380756"/>
                  <a:ext cx="528852" cy="37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*</a:t>
                  </a: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2370285" y="1145087"/>
                  <a:ext cx="608982" cy="3737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**</a:t>
                  </a:r>
                </a:p>
              </p:txBody>
            </p:sp>
          </p:grpSp>
          <p:grpSp>
            <p:nvGrpSpPr>
              <p:cNvPr id="35" name="Group 34"/>
              <p:cNvGrpSpPr/>
              <p:nvPr/>
            </p:nvGrpSpPr>
            <p:grpSpPr>
              <a:xfrm>
                <a:off x="889857" y="4267074"/>
                <a:ext cx="692188" cy="42095"/>
                <a:chOff x="3099332" y="1078702"/>
                <a:chExt cx="670293" cy="31706"/>
              </a:xfrm>
            </p:grpSpPr>
            <p:cxnSp>
              <p:nvCxnSpPr>
                <p:cNvPr id="40" name="Straight Connector 39"/>
                <p:cNvCxnSpPr/>
                <p:nvPr/>
              </p:nvCxnSpPr>
              <p:spPr>
                <a:xfrm>
                  <a:off x="3099332" y="1079380"/>
                  <a:ext cx="67029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Connector 40"/>
                <p:cNvCxnSpPr/>
                <p:nvPr/>
              </p:nvCxnSpPr>
              <p:spPr>
                <a:xfrm>
                  <a:off x="3099955" y="1078702"/>
                  <a:ext cx="0" cy="3170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/>
                <p:cNvCxnSpPr/>
                <p:nvPr/>
              </p:nvCxnSpPr>
              <p:spPr>
                <a:xfrm>
                  <a:off x="3769307" y="1078702"/>
                  <a:ext cx="0" cy="3170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6" name="Straight Connector 35"/>
              <p:cNvCxnSpPr/>
              <p:nvPr/>
            </p:nvCxnSpPr>
            <p:spPr>
              <a:xfrm>
                <a:off x="890500" y="4401241"/>
                <a:ext cx="0" cy="4209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1344800" y="4401240"/>
                <a:ext cx="0" cy="4209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890500" y="4471246"/>
                <a:ext cx="0" cy="4209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>
                <a:off x="1118444" y="4471246"/>
                <a:ext cx="0" cy="4209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2" name="Group 61"/>
          <p:cNvGrpSpPr/>
          <p:nvPr/>
        </p:nvGrpSpPr>
        <p:grpSpPr>
          <a:xfrm>
            <a:off x="3054621" y="2117175"/>
            <a:ext cx="1440000" cy="1620000"/>
            <a:chOff x="3054621" y="2117175"/>
            <a:chExt cx="1440000" cy="1620000"/>
          </a:xfrm>
        </p:grpSpPr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67864214"/>
                </p:ext>
              </p:extLst>
            </p:nvPr>
          </p:nvGraphicFramePr>
          <p:xfrm>
            <a:off x="3054621" y="2117175"/>
            <a:ext cx="144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48" name="Group 47"/>
            <p:cNvGrpSpPr/>
            <p:nvPr/>
          </p:nvGrpSpPr>
          <p:grpSpPr>
            <a:xfrm>
              <a:off x="3631279" y="2259435"/>
              <a:ext cx="692188" cy="268093"/>
              <a:chOff x="3089238" y="858950"/>
              <a:chExt cx="692188" cy="268093"/>
            </a:xfrm>
          </p:grpSpPr>
          <p:grpSp>
            <p:nvGrpSpPr>
              <p:cNvPr id="49" name="Group 48"/>
              <p:cNvGrpSpPr/>
              <p:nvPr/>
            </p:nvGrpSpPr>
            <p:grpSpPr>
              <a:xfrm>
                <a:off x="3092413" y="1041821"/>
                <a:ext cx="444650" cy="28504"/>
                <a:chOff x="3090493" y="1051519"/>
                <a:chExt cx="430585" cy="20395"/>
              </a:xfrm>
            </p:grpSpPr>
            <p:cxnSp>
              <p:nvCxnSpPr>
                <p:cNvPr id="59" name="Straight Connector 58"/>
                <p:cNvCxnSpPr/>
                <p:nvPr/>
              </p:nvCxnSpPr>
              <p:spPr>
                <a:xfrm>
                  <a:off x="3090493" y="1051519"/>
                  <a:ext cx="43058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Connector 59"/>
                <p:cNvCxnSpPr/>
                <p:nvPr/>
              </p:nvCxnSpPr>
              <p:spPr>
                <a:xfrm>
                  <a:off x="3090609" y="1053883"/>
                  <a:ext cx="0" cy="1803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Straight Connector 60"/>
                <p:cNvCxnSpPr/>
                <p:nvPr/>
              </p:nvCxnSpPr>
              <p:spPr>
                <a:xfrm>
                  <a:off x="3520495" y="1053883"/>
                  <a:ext cx="0" cy="1803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0" name="TextBox 49"/>
              <p:cNvSpPr txBox="1"/>
              <p:nvPr/>
            </p:nvSpPr>
            <p:spPr>
              <a:xfrm>
                <a:off x="3251355" y="858950"/>
                <a:ext cx="3898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*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1" name="Group 50"/>
              <p:cNvGrpSpPr/>
              <p:nvPr/>
            </p:nvGrpSpPr>
            <p:grpSpPr>
              <a:xfrm>
                <a:off x="3089238" y="982258"/>
                <a:ext cx="692188" cy="25200"/>
                <a:chOff x="3085155" y="1004429"/>
                <a:chExt cx="670293" cy="18981"/>
              </a:xfrm>
            </p:grpSpPr>
            <p:cxnSp>
              <p:nvCxnSpPr>
                <p:cNvPr id="56" name="Straight Connector 55"/>
                <p:cNvCxnSpPr/>
                <p:nvPr/>
              </p:nvCxnSpPr>
              <p:spPr>
                <a:xfrm>
                  <a:off x="3085155" y="1004448"/>
                  <a:ext cx="67029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Straight Connector 56"/>
                <p:cNvCxnSpPr/>
                <p:nvPr/>
              </p:nvCxnSpPr>
              <p:spPr>
                <a:xfrm>
                  <a:off x="3087877" y="1004429"/>
                  <a:ext cx="0" cy="1898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Straight Connector 57"/>
                <p:cNvCxnSpPr/>
                <p:nvPr/>
              </p:nvCxnSpPr>
              <p:spPr>
                <a:xfrm>
                  <a:off x="3754627" y="1004429"/>
                  <a:ext cx="0" cy="1898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2" name="Group 51"/>
              <p:cNvGrpSpPr/>
              <p:nvPr/>
            </p:nvGrpSpPr>
            <p:grpSpPr>
              <a:xfrm>
                <a:off x="3092248" y="1101842"/>
                <a:ext cx="229202" cy="25201"/>
                <a:chOff x="3094725" y="1113319"/>
                <a:chExt cx="221952" cy="17479"/>
              </a:xfrm>
            </p:grpSpPr>
            <p:cxnSp>
              <p:nvCxnSpPr>
                <p:cNvPr id="53" name="Straight Connector 52"/>
                <p:cNvCxnSpPr/>
                <p:nvPr/>
              </p:nvCxnSpPr>
              <p:spPr>
                <a:xfrm>
                  <a:off x="3094725" y="1113342"/>
                  <a:ext cx="22195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/>
                <p:cNvCxnSpPr/>
                <p:nvPr/>
              </p:nvCxnSpPr>
              <p:spPr>
                <a:xfrm>
                  <a:off x="3096058" y="1113319"/>
                  <a:ext cx="0" cy="1747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Connector 54"/>
                <p:cNvCxnSpPr/>
                <p:nvPr/>
              </p:nvCxnSpPr>
              <p:spPr>
                <a:xfrm>
                  <a:off x="3316486" y="1113320"/>
                  <a:ext cx="0" cy="1747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27975608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742644" y="1315818"/>
            <a:ext cx="1643697" cy="987703"/>
            <a:chOff x="4562684" y="2830200"/>
            <a:chExt cx="1376446" cy="815774"/>
          </a:xfrm>
        </p:grpSpPr>
        <p:pic>
          <p:nvPicPr>
            <p:cNvPr id="3" name="Picture 2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28" t="34995" r="64936" b="56637"/>
            <a:stretch/>
          </p:blipFill>
          <p:spPr>
            <a:xfrm>
              <a:off x="5037743" y="3431893"/>
              <a:ext cx="901387" cy="2140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Picture 3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25" t="40197" r="62602" b="51262"/>
            <a:stretch/>
          </p:blipFill>
          <p:spPr>
            <a:xfrm>
              <a:off x="5037743" y="3182989"/>
              <a:ext cx="901387" cy="2140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TextBox 4"/>
            <p:cNvSpPr txBox="1"/>
            <p:nvPr/>
          </p:nvSpPr>
          <p:spPr>
            <a:xfrm rot="17498121">
              <a:off x="5061339" y="2972898"/>
              <a:ext cx="291539" cy="180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7498121">
              <a:off x="5232037" y="2934748"/>
              <a:ext cx="389512" cy="180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b2∆ 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7498121">
              <a:off x="5437784" y="2934748"/>
              <a:ext cx="374947" cy="180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r1∆ 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7498121">
              <a:off x="5621630" y="2927978"/>
              <a:ext cx="374947" cy="180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tr1∆ 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562684" y="3204608"/>
              <a:ext cx="511711" cy="177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ma1-flag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654900" y="3445393"/>
              <a:ext cx="382843" cy="177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644627" y="1048659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714720" y="104865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68051" y="2878451"/>
            <a:ext cx="538812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algn="just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b2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not involved in regulation of PMA1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. (a)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levels were measured in 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, pib2∆, tor1∆ ,gtr1∆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 by qPCR (*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-flag tag was expressed chromosomally in indicated WT and mutant strains. WCE was prepared and Pma1 protein levels were analyzed by western blot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940721" y="1153555"/>
            <a:ext cx="1440000" cy="1620000"/>
            <a:chOff x="940721" y="1153555"/>
            <a:chExt cx="1440000" cy="1620000"/>
          </a:xfrm>
        </p:grpSpPr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98788307"/>
                </p:ext>
              </p:extLst>
            </p:nvPr>
          </p:nvGraphicFramePr>
          <p:xfrm>
            <a:off x="940721" y="1153555"/>
            <a:ext cx="144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15" name="Group 14"/>
            <p:cNvGrpSpPr/>
            <p:nvPr/>
          </p:nvGrpSpPr>
          <p:grpSpPr>
            <a:xfrm>
              <a:off x="1554805" y="1356264"/>
              <a:ext cx="692192" cy="435008"/>
              <a:chOff x="3089234" y="843435"/>
              <a:chExt cx="692192" cy="435008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3089234" y="1046845"/>
                <a:ext cx="447223" cy="25965"/>
                <a:chOff x="3087418" y="1055154"/>
                <a:chExt cx="433077" cy="18579"/>
              </a:xfrm>
            </p:grpSpPr>
            <p:cxnSp>
              <p:nvCxnSpPr>
                <p:cNvPr id="26" name="Straight Connector 25"/>
                <p:cNvCxnSpPr/>
                <p:nvPr/>
              </p:nvCxnSpPr>
              <p:spPr>
                <a:xfrm>
                  <a:off x="3087422" y="1055154"/>
                  <a:ext cx="43058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/>
                <p:cNvCxnSpPr/>
                <p:nvPr/>
              </p:nvCxnSpPr>
              <p:spPr>
                <a:xfrm>
                  <a:off x="3087418" y="1055702"/>
                  <a:ext cx="0" cy="1803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/>
                <p:cNvCxnSpPr/>
                <p:nvPr/>
              </p:nvCxnSpPr>
              <p:spPr>
                <a:xfrm>
                  <a:off x="3520495" y="1055702"/>
                  <a:ext cx="0" cy="1803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" name="TextBox 16"/>
              <p:cNvSpPr txBox="1"/>
              <p:nvPr/>
            </p:nvSpPr>
            <p:spPr>
              <a:xfrm>
                <a:off x="3256835" y="843435"/>
                <a:ext cx="3898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*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8" name="Group 17"/>
              <p:cNvGrpSpPr/>
              <p:nvPr/>
            </p:nvGrpSpPr>
            <p:grpSpPr>
              <a:xfrm>
                <a:off x="3089238" y="981202"/>
                <a:ext cx="692188" cy="25200"/>
                <a:chOff x="3085155" y="1003634"/>
                <a:chExt cx="670293" cy="18981"/>
              </a:xfrm>
            </p:grpSpPr>
            <p:cxnSp>
              <p:nvCxnSpPr>
                <p:cNvPr id="23" name="Straight Connector 22"/>
                <p:cNvCxnSpPr/>
                <p:nvPr/>
              </p:nvCxnSpPr>
              <p:spPr>
                <a:xfrm>
                  <a:off x="3085155" y="1004448"/>
                  <a:ext cx="67029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/>
                <p:cNvCxnSpPr/>
                <p:nvPr/>
              </p:nvCxnSpPr>
              <p:spPr>
                <a:xfrm>
                  <a:off x="3085155" y="1003634"/>
                  <a:ext cx="0" cy="1898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Straight Connector 24"/>
                <p:cNvCxnSpPr/>
                <p:nvPr/>
              </p:nvCxnSpPr>
              <p:spPr>
                <a:xfrm>
                  <a:off x="3754627" y="1003634"/>
                  <a:ext cx="0" cy="1898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" name="Group 18"/>
              <p:cNvGrpSpPr/>
              <p:nvPr/>
            </p:nvGrpSpPr>
            <p:grpSpPr>
              <a:xfrm>
                <a:off x="3089238" y="1253220"/>
                <a:ext cx="229202" cy="25223"/>
                <a:chOff x="3091810" y="1218294"/>
                <a:chExt cx="221952" cy="17494"/>
              </a:xfrm>
            </p:grpSpPr>
            <p:cxnSp>
              <p:nvCxnSpPr>
                <p:cNvPr id="20" name="Straight Connector 19"/>
                <p:cNvCxnSpPr/>
                <p:nvPr/>
              </p:nvCxnSpPr>
              <p:spPr>
                <a:xfrm>
                  <a:off x="3091810" y="1218461"/>
                  <a:ext cx="22195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/>
                <p:cNvCxnSpPr/>
                <p:nvPr/>
              </p:nvCxnSpPr>
              <p:spPr>
                <a:xfrm>
                  <a:off x="3091810" y="1218310"/>
                  <a:ext cx="0" cy="1747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Connector 21"/>
                <p:cNvCxnSpPr/>
                <p:nvPr/>
              </p:nvCxnSpPr>
              <p:spPr>
                <a:xfrm>
                  <a:off x="3313571" y="1218294"/>
                  <a:ext cx="0" cy="1747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4985918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45052" y="4927297"/>
            <a:ext cx="4661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 calibrat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ve for determination of cytoplasmic pH.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more details, refer to materials and method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0225635"/>
              </p:ext>
            </p:extLst>
          </p:nvPr>
        </p:nvGraphicFramePr>
        <p:xfrm>
          <a:off x="1307486" y="1821201"/>
          <a:ext cx="28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1840808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32"/>
          <p:cNvGrpSpPr/>
          <p:nvPr/>
        </p:nvGrpSpPr>
        <p:grpSpPr>
          <a:xfrm>
            <a:off x="338895" y="424045"/>
            <a:ext cx="2609213" cy="2738286"/>
            <a:chOff x="930793" y="616662"/>
            <a:chExt cx="4124253" cy="4328274"/>
          </a:xfrm>
        </p:grpSpPr>
        <p:pic>
          <p:nvPicPr>
            <p:cNvPr id="3" name="그림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06365" y="1239663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" name="그림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06365" y="2138134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" name="그림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506364" y="3036606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" name="그림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506364" y="3935076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" name="그림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303119" y="1239663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8" name="그림 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303119" y="2138134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9" name="그림 1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303117" y="3036606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0" name="그림 1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303115" y="3935076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1" name="그림 1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404740" y="1239663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2" name="그림 13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404740" y="2138134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3" name="그림 1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404739" y="3036606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4" name="그림 15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404737" y="3935076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" name="그림 16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201495" y="2138134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6" name="그림 17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201495" y="1239663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7" name="그림 18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201495" y="3036606"/>
              <a:ext cx="853551" cy="85355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8" name="그림 19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201495" y="3935076"/>
              <a:ext cx="853551" cy="853551"/>
            </a:xfrm>
            <a:prstGeom prst="rect">
              <a:avLst/>
            </a:prstGeom>
            <a:ln>
              <a:noFill/>
            </a:ln>
          </p:spPr>
        </p:pic>
        <p:sp>
          <p:nvSpPr>
            <p:cNvPr id="19" name="TextBox 18"/>
            <p:cNvSpPr txBox="1"/>
            <p:nvPr/>
          </p:nvSpPr>
          <p:spPr>
            <a:xfrm>
              <a:off x="1379386" y="859907"/>
              <a:ext cx="1144799" cy="38918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318839" y="859907"/>
              <a:ext cx="1144799" cy="38918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2∆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193095" y="859907"/>
              <a:ext cx="1144799" cy="38918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r1∆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201495" y="616662"/>
              <a:ext cx="853551" cy="63243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r1</a:t>
              </a:r>
              <a:r>
                <a:rPr lang="en-US" altLang="ko-KR" sz="10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∆</a:t>
              </a:r>
            </a:p>
            <a:p>
              <a:pPr algn="ctr"/>
              <a:r>
                <a:rPr lang="en-US" altLang="ko-KR" sz="10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2</a:t>
              </a:r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∆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723257" y="1505685"/>
              <a:ext cx="1144800" cy="3405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C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16200000">
              <a:off x="548359" y="2317303"/>
              <a:ext cx="1300003" cy="53513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h1-mCherry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586709" y="3333805"/>
              <a:ext cx="1417897" cy="3405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in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723257" y="4202265"/>
              <a:ext cx="1144800" cy="3405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e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038699" y="3856657"/>
              <a:ext cx="266743" cy="4378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344959" y="3263311"/>
            <a:ext cx="2989576" cy="2840708"/>
            <a:chOff x="1703854" y="1291787"/>
            <a:chExt cx="3529267" cy="3353525"/>
          </a:xfrm>
        </p:grpSpPr>
        <p:grpSp>
          <p:nvGrpSpPr>
            <p:cNvPr id="30" name="Group 29"/>
            <p:cNvGrpSpPr/>
            <p:nvPr/>
          </p:nvGrpSpPr>
          <p:grpSpPr>
            <a:xfrm>
              <a:off x="1703854" y="1291787"/>
              <a:ext cx="3529267" cy="3353525"/>
              <a:chOff x="6017458" y="555890"/>
              <a:chExt cx="4705690" cy="4471367"/>
            </a:xfrm>
          </p:grpSpPr>
          <p:pic>
            <p:nvPicPr>
              <p:cNvPr id="35" name="그림 31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6610175" y="1096282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6" name="그림 32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6610175" y="1988517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7" name="그림 34"/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7520326" y="1096282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8" name="그림 35"/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7520326" y="1988517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9" name="그림 37"/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8430487" y="1096282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40" name="그림 38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8426604" y="1988516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41" name="그림 40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9321214" y="1096282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42" name="그림 41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9321214" y="1988517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43" name="TextBox 42"/>
              <p:cNvSpPr txBox="1"/>
              <p:nvPr/>
            </p:nvSpPr>
            <p:spPr>
              <a:xfrm>
                <a:off x="6599117" y="749669"/>
                <a:ext cx="861026" cy="3391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lang="ko-KR" alt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7520325" y="749669"/>
                <a:ext cx="869411" cy="3391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2∆</a:t>
                </a:r>
                <a:endParaRPr lang="ko-KR" alt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8426605" y="749669"/>
                <a:ext cx="849978" cy="3391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r1∆</a:t>
                </a:r>
                <a:endParaRPr lang="ko-KR" alt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9313448" y="555890"/>
                <a:ext cx="857744" cy="53289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r1</a:t>
                </a:r>
                <a:r>
                  <a:rPr lang="en-US" altLang="ko-KR" sz="8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∆</a:t>
                </a:r>
              </a:p>
              <a:p>
                <a:pPr algn="ctr"/>
                <a:r>
                  <a:rPr lang="en-US" altLang="ko-KR" sz="8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2</a:t>
                </a:r>
                <a:r>
                  <a:rPr lang="en-US" altLang="ko-KR" sz="8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∆</a:t>
                </a:r>
                <a:endParaRPr lang="ko-KR" alt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6017458" y="4657924"/>
                <a:ext cx="4705690" cy="36933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bsence of glucose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8" name="그림 52"/>
              <p:cNvPicPr>
                <a:picLocks noChangeAspect="1"/>
              </p:cNvPicPr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6610175" y="2881493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49" name="그림 53"/>
              <p:cNvPicPr>
                <a:picLocks noChangeAspect="1"/>
              </p:cNvPicPr>
              <p:nvPr/>
            </p:nvPicPr>
            <p:blipFill>
              <a:blip r:embed="rId27"/>
              <a:stretch>
                <a:fillRect/>
              </a:stretch>
            </p:blipFill>
            <p:spPr>
              <a:xfrm>
                <a:off x="6610175" y="3776217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0" name="그림 58"/>
              <p:cNvPicPr>
                <a:picLocks noChangeAspect="1"/>
              </p:cNvPicPr>
              <p:nvPr/>
            </p:nvPicPr>
            <p:blipFill>
              <a:blip r:embed="rId28"/>
              <a:stretch>
                <a:fillRect/>
              </a:stretch>
            </p:blipFill>
            <p:spPr>
              <a:xfrm>
                <a:off x="7520326" y="2881493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1" name="그림 59"/>
              <p:cNvPicPr>
                <a:picLocks noChangeAspect="1"/>
              </p:cNvPicPr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7520326" y="3776217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2" name="그림 64"/>
              <p:cNvPicPr>
                <a:picLocks noChangeAspect="1"/>
              </p:cNvPicPr>
              <p:nvPr/>
            </p:nvPicPr>
            <p:blipFill>
              <a:blip r:embed="rId30"/>
              <a:stretch>
                <a:fillRect/>
              </a:stretch>
            </p:blipFill>
            <p:spPr>
              <a:xfrm>
                <a:off x="8417377" y="2881493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3" name="그림 65"/>
              <p:cNvPicPr>
                <a:picLocks noChangeAspect="1"/>
              </p:cNvPicPr>
              <p:nvPr/>
            </p:nvPicPr>
            <p:blipFill>
              <a:blip r:embed="rId31"/>
              <a:stretch>
                <a:fillRect/>
              </a:stretch>
            </p:blipFill>
            <p:spPr>
              <a:xfrm>
                <a:off x="8417375" y="3776217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4" name="그림 68"/>
              <p:cNvPicPr>
                <a:picLocks noChangeAspect="1"/>
              </p:cNvPicPr>
              <p:nvPr/>
            </p:nvPicPr>
            <p:blipFill>
              <a:blip r:embed="rId32"/>
              <a:stretch>
                <a:fillRect/>
              </a:stretch>
            </p:blipFill>
            <p:spPr>
              <a:xfrm>
                <a:off x="9321214" y="2881493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5" name="그림 69"/>
              <p:cNvPicPr>
                <a:picLocks noChangeAspect="1"/>
              </p:cNvPicPr>
              <p:nvPr/>
            </p:nvPicPr>
            <p:blipFill>
              <a:blip r:embed="rId33"/>
              <a:stretch>
                <a:fillRect/>
              </a:stretch>
            </p:blipFill>
            <p:spPr>
              <a:xfrm>
                <a:off x="9321216" y="3776217"/>
                <a:ext cx="849978" cy="849978"/>
              </a:xfrm>
              <a:prstGeom prst="rect">
                <a:avLst/>
              </a:prstGeom>
              <a:ln>
                <a:noFill/>
              </a:ln>
            </p:spPr>
          </p:pic>
        </p:grpSp>
        <p:sp>
          <p:nvSpPr>
            <p:cNvPr id="31" name="TextBox 30"/>
            <p:cNvSpPr txBox="1"/>
            <p:nvPr/>
          </p:nvSpPr>
          <p:spPr>
            <a:xfrm rot="16200000">
              <a:off x="1693887" y="1882111"/>
              <a:ext cx="636481" cy="25433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C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1697112" y="2547288"/>
              <a:ext cx="623848" cy="26052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h1</a:t>
              </a:r>
              <a:endParaRPr lang="ko-KR" alt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1697111" y="3217657"/>
              <a:ext cx="623849" cy="26052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ma5</a:t>
              </a:r>
              <a:endParaRPr lang="ko-KR" alt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1690722" y="3885998"/>
              <a:ext cx="636627" cy="26052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rge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6" name="TextBox 75"/>
          <p:cNvSpPr txBox="1"/>
          <p:nvPr/>
        </p:nvSpPr>
        <p:spPr>
          <a:xfrm>
            <a:off x="317224" y="528882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316080" y="3274745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241760" y="6152313"/>
            <a:ext cx="560805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algn="just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endent change in vacuolar acidity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Ag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lower panel represent exact age (Age 5)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&gt; 100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all strains.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cuolar acidity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by quinacrine staining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aged Vph1-mcherry 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indicated mutant strains. (b)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in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does not affect vacuolar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embly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onentially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ing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starved for glucose and vacuolar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ase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assembly was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zed by fluorescence microscopy by co-expressing Vph1-mcherry and Vma5-GFP.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6" name="Group 55"/>
          <p:cNvGrpSpPr/>
          <p:nvPr/>
        </p:nvGrpSpPr>
        <p:grpSpPr>
          <a:xfrm>
            <a:off x="3011687" y="1270459"/>
            <a:ext cx="1440000" cy="1620000"/>
            <a:chOff x="3011687" y="1270459"/>
            <a:chExt cx="1440000" cy="1620000"/>
          </a:xfrm>
        </p:grpSpPr>
        <p:graphicFrame>
          <p:nvGraphicFramePr>
            <p:cNvPr id="65" name="차트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89769990"/>
                </p:ext>
              </p:extLst>
            </p:nvPr>
          </p:nvGraphicFramePr>
          <p:xfrm>
            <a:off x="3011687" y="1270459"/>
            <a:ext cx="144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4"/>
            </a:graphicData>
          </a:graphic>
        </p:graphicFrame>
        <p:grpSp>
          <p:nvGrpSpPr>
            <p:cNvPr id="79" name="Group 78"/>
            <p:cNvGrpSpPr/>
            <p:nvPr/>
          </p:nvGrpSpPr>
          <p:grpSpPr>
            <a:xfrm>
              <a:off x="3688322" y="1407020"/>
              <a:ext cx="595761" cy="241699"/>
              <a:chOff x="3973265" y="679351"/>
              <a:chExt cx="714759" cy="241699"/>
            </a:xfrm>
          </p:grpSpPr>
          <p:grpSp>
            <p:nvGrpSpPr>
              <p:cNvPr id="80" name="Group 79"/>
              <p:cNvGrpSpPr/>
              <p:nvPr/>
            </p:nvGrpSpPr>
            <p:grpSpPr>
              <a:xfrm>
                <a:off x="3973265" y="679351"/>
                <a:ext cx="714759" cy="216507"/>
                <a:chOff x="8921079" y="4780691"/>
                <a:chExt cx="1051159" cy="187460"/>
              </a:xfrm>
            </p:grpSpPr>
            <p:cxnSp>
              <p:nvCxnSpPr>
                <p:cNvPr id="87" name="직선 연결선 33"/>
                <p:cNvCxnSpPr/>
                <p:nvPr/>
              </p:nvCxnSpPr>
              <p:spPr>
                <a:xfrm>
                  <a:off x="8926250" y="4968151"/>
                  <a:ext cx="36373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직선 연결선 30"/>
                <p:cNvCxnSpPr/>
                <p:nvPr/>
              </p:nvCxnSpPr>
              <p:spPr>
                <a:xfrm>
                  <a:off x="9647084" y="4899043"/>
                  <a:ext cx="325154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직선 연결선 28"/>
                <p:cNvCxnSpPr/>
                <p:nvPr/>
              </p:nvCxnSpPr>
              <p:spPr>
                <a:xfrm>
                  <a:off x="8921079" y="4899110"/>
                  <a:ext cx="65506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0" name="직사각형 26"/>
                <p:cNvSpPr/>
                <p:nvPr/>
              </p:nvSpPr>
              <p:spPr>
                <a:xfrm>
                  <a:off x="9601032" y="4780691"/>
                  <a:ext cx="347016" cy="18653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직사각형 26"/>
                <p:cNvSpPr/>
                <p:nvPr/>
              </p:nvSpPr>
              <p:spPr>
                <a:xfrm>
                  <a:off x="8943787" y="4780691"/>
                  <a:ext cx="497894" cy="18653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*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81" name="Straight Connector 80"/>
              <p:cNvCxnSpPr/>
              <p:nvPr/>
            </p:nvCxnSpPr>
            <p:spPr>
              <a:xfrm>
                <a:off x="3975776" y="816894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>
                <a:off x="4415820" y="816894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>
                <a:off x="3979037" y="895850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4222284" y="895850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>
                <a:off x="4468391" y="816894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4686805" y="816894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8" name="Group 27"/>
          <p:cNvGrpSpPr/>
          <p:nvPr/>
        </p:nvGrpSpPr>
        <p:grpSpPr>
          <a:xfrm>
            <a:off x="4409818" y="1270459"/>
            <a:ext cx="1440000" cy="1620000"/>
            <a:chOff x="4409818" y="1270459"/>
            <a:chExt cx="1440000" cy="1620000"/>
          </a:xfrm>
        </p:grpSpPr>
        <p:graphicFrame>
          <p:nvGraphicFramePr>
            <p:cNvPr id="57" name="차트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3415156"/>
                </p:ext>
              </p:extLst>
            </p:nvPr>
          </p:nvGraphicFramePr>
          <p:xfrm>
            <a:off x="4409818" y="1270459"/>
            <a:ext cx="144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5"/>
            </a:graphicData>
          </a:graphic>
        </p:graphicFrame>
        <p:grpSp>
          <p:nvGrpSpPr>
            <p:cNvPr id="92" name="Group 91"/>
            <p:cNvGrpSpPr/>
            <p:nvPr/>
          </p:nvGrpSpPr>
          <p:grpSpPr>
            <a:xfrm>
              <a:off x="5082545" y="1668374"/>
              <a:ext cx="598682" cy="241681"/>
              <a:chOff x="3969764" y="679369"/>
              <a:chExt cx="718264" cy="241681"/>
            </a:xfrm>
          </p:grpSpPr>
          <p:grpSp>
            <p:nvGrpSpPr>
              <p:cNvPr id="93" name="Group 92"/>
              <p:cNvGrpSpPr/>
              <p:nvPr/>
            </p:nvGrpSpPr>
            <p:grpSpPr>
              <a:xfrm>
                <a:off x="3969764" y="679369"/>
                <a:ext cx="718264" cy="215444"/>
                <a:chOff x="8915925" y="4780691"/>
                <a:chExt cx="1056313" cy="186539"/>
              </a:xfrm>
            </p:grpSpPr>
            <p:cxnSp>
              <p:nvCxnSpPr>
                <p:cNvPr id="100" name="직선 연결선 33"/>
                <p:cNvCxnSpPr/>
                <p:nvPr/>
              </p:nvCxnSpPr>
              <p:spPr>
                <a:xfrm>
                  <a:off x="8926250" y="4964522"/>
                  <a:ext cx="363731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직선 연결선 30"/>
                <p:cNvCxnSpPr/>
                <p:nvPr/>
              </p:nvCxnSpPr>
              <p:spPr>
                <a:xfrm>
                  <a:off x="9647084" y="4899043"/>
                  <a:ext cx="325154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직선 연결선 28"/>
                <p:cNvCxnSpPr/>
                <p:nvPr/>
              </p:nvCxnSpPr>
              <p:spPr>
                <a:xfrm>
                  <a:off x="8915925" y="4899110"/>
                  <a:ext cx="65506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3" name="직사각형 26"/>
                <p:cNvSpPr/>
                <p:nvPr/>
              </p:nvSpPr>
              <p:spPr>
                <a:xfrm>
                  <a:off x="9601032" y="4780691"/>
                  <a:ext cx="347016" cy="18653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4" name="직사각형 26"/>
                <p:cNvSpPr/>
                <p:nvPr/>
              </p:nvSpPr>
              <p:spPr>
                <a:xfrm>
                  <a:off x="8999688" y="4780691"/>
                  <a:ext cx="416331" cy="18653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94" name="Straight Connector 93"/>
              <p:cNvCxnSpPr/>
              <p:nvPr/>
            </p:nvCxnSpPr>
            <p:spPr>
              <a:xfrm>
                <a:off x="3970258" y="816024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>
                <a:off x="4414600" y="818791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/>
              <p:cNvCxnSpPr/>
              <p:nvPr/>
            </p:nvCxnSpPr>
            <p:spPr>
              <a:xfrm>
                <a:off x="3975534" y="895850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/>
              <p:cNvCxnSpPr/>
              <p:nvPr/>
            </p:nvCxnSpPr>
            <p:spPr>
              <a:xfrm>
                <a:off x="4222285" y="895850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/>
              <p:cNvCxnSpPr/>
              <p:nvPr/>
            </p:nvCxnSpPr>
            <p:spPr>
              <a:xfrm>
                <a:off x="4469212" y="819815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>
                <a:off x="4684977" y="819815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600341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80998" y="710804"/>
            <a:ext cx="2608930" cy="1547271"/>
            <a:chOff x="1786759" y="1298790"/>
            <a:chExt cx="3092092" cy="1972711"/>
          </a:xfrm>
        </p:grpSpPr>
        <p:grpSp>
          <p:nvGrpSpPr>
            <p:cNvPr id="3" name="그룹 19"/>
            <p:cNvGrpSpPr/>
            <p:nvPr/>
          </p:nvGrpSpPr>
          <p:grpSpPr>
            <a:xfrm>
              <a:off x="1786759" y="1298790"/>
              <a:ext cx="3092092" cy="1774565"/>
              <a:chOff x="2044041" y="753857"/>
              <a:chExt cx="3092092" cy="1774565"/>
            </a:xfrm>
          </p:grpSpPr>
          <p:pic>
            <p:nvPicPr>
              <p:cNvPr id="6" name="Picture 6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306" r="31897" b="1840"/>
              <a:stretch/>
            </p:blipFill>
            <p:spPr>
              <a:xfrm>
                <a:off x="2985258" y="858519"/>
                <a:ext cx="1066676" cy="1560553"/>
              </a:xfrm>
              <a:prstGeom prst="rect">
                <a:avLst/>
              </a:prstGeom>
            </p:spPr>
          </p:pic>
          <p:pic>
            <p:nvPicPr>
              <p:cNvPr id="7" name="Picture 4"/>
              <p:cNvPicPr preferRelativeResize="0">
                <a:picLocks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703" t="1515" r="26810" b="8646"/>
              <a:stretch/>
            </p:blipFill>
            <p:spPr>
              <a:xfrm>
                <a:off x="4069457" y="858519"/>
                <a:ext cx="1066676" cy="1560553"/>
              </a:xfrm>
              <a:prstGeom prst="rect">
                <a:avLst/>
              </a:prstGeom>
            </p:spPr>
          </p:pic>
          <p:sp>
            <p:nvSpPr>
              <p:cNvPr id="8" name="직사각형 20"/>
              <p:cNvSpPr>
                <a:spLocks noChangeArrowheads="1"/>
              </p:cNvSpPr>
              <p:nvPr/>
            </p:nvSpPr>
            <p:spPr bwMode="auto">
              <a:xfrm>
                <a:off x="2559351" y="753857"/>
                <a:ext cx="466594" cy="3973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r">
                  <a:lnSpc>
                    <a:spcPct val="150000"/>
                  </a:lnSpc>
                  <a:spcBef>
                    <a:spcPts val="400"/>
                  </a:spcBef>
                  <a:buFontTx/>
                  <a:buNone/>
                </a:pPr>
                <a:r>
                  <a:rPr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kumimoji="0"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직사각형 20"/>
              <p:cNvSpPr>
                <a:spLocks noChangeArrowheads="1"/>
              </p:cNvSpPr>
              <p:nvPr/>
            </p:nvSpPr>
            <p:spPr bwMode="auto">
              <a:xfrm>
                <a:off x="2478320" y="946339"/>
                <a:ext cx="580579" cy="3973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r">
                  <a:lnSpc>
                    <a:spcPct val="150000"/>
                  </a:lnSpc>
                  <a:spcBef>
                    <a:spcPts val="400"/>
                  </a:spcBef>
                  <a:buFontTx/>
                  <a:buNone/>
                </a:pPr>
                <a:r>
                  <a:rPr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2</a:t>
                </a:r>
                <a:r>
                  <a:rPr kumimoji="0"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∆</a:t>
                </a:r>
                <a:endParaRPr kumimoji="0"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직사각형 20"/>
              <p:cNvSpPr>
                <a:spLocks noChangeArrowheads="1"/>
              </p:cNvSpPr>
              <p:nvPr/>
            </p:nvSpPr>
            <p:spPr bwMode="auto">
              <a:xfrm>
                <a:off x="2377995" y="1144013"/>
                <a:ext cx="680904" cy="3973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r">
                  <a:lnSpc>
                    <a:spcPct val="150000"/>
                  </a:lnSpc>
                  <a:spcBef>
                    <a:spcPts val="400"/>
                  </a:spcBef>
                  <a:buFontTx/>
                  <a:buNone/>
                </a:pPr>
                <a:r>
                  <a:rPr kumimoji="0"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ns1∆</a:t>
                </a:r>
                <a:endParaRPr kumimoji="0"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직사각형 20"/>
              <p:cNvSpPr>
                <a:spLocks noChangeArrowheads="1"/>
              </p:cNvSpPr>
              <p:nvPr/>
            </p:nvSpPr>
            <p:spPr bwMode="auto">
              <a:xfrm>
                <a:off x="2112372" y="1345412"/>
                <a:ext cx="946527" cy="3973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r">
                  <a:lnSpc>
                    <a:spcPct val="150000"/>
                  </a:lnSpc>
                  <a:spcBef>
                    <a:spcPts val="400"/>
                  </a:spcBef>
                  <a:buFontTx/>
                  <a:buNone/>
                </a:pPr>
                <a:r>
                  <a:rPr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ns1</a:t>
                </a:r>
                <a:r>
                  <a:rPr kumimoji="0"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∆sir2∆</a:t>
                </a:r>
                <a:endParaRPr kumimoji="0"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직사각형 20"/>
              <p:cNvSpPr>
                <a:spLocks noChangeArrowheads="1"/>
              </p:cNvSpPr>
              <p:nvPr/>
            </p:nvSpPr>
            <p:spPr bwMode="auto">
              <a:xfrm>
                <a:off x="2209495" y="1547182"/>
                <a:ext cx="849404" cy="3973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r">
                  <a:lnSpc>
                    <a:spcPct val="150000"/>
                  </a:lnSpc>
                  <a:spcBef>
                    <a:spcPts val="400"/>
                  </a:spcBef>
                  <a:buFontTx/>
                  <a:buNone/>
                </a:pPr>
                <a:r>
                  <a:rPr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2-A</a:t>
                </a:r>
                <a:endParaRPr kumimoji="0"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직사각형 20"/>
              <p:cNvSpPr>
                <a:spLocks noChangeArrowheads="1"/>
              </p:cNvSpPr>
              <p:nvPr/>
            </p:nvSpPr>
            <p:spPr bwMode="auto">
              <a:xfrm>
                <a:off x="2377995" y="1733806"/>
                <a:ext cx="680904" cy="3973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r">
                  <a:lnSpc>
                    <a:spcPct val="150000"/>
                  </a:lnSpc>
                  <a:spcBef>
                    <a:spcPts val="400"/>
                  </a:spcBef>
                  <a:buFontTx/>
                  <a:buNone/>
                </a:pPr>
                <a:r>
                  <a:rPr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2-E</a:t>
                </a:r>
                <a:endParaRPr kumimoji="0"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직사각형 20"/>
              <p:cNvSpPr>
                <a:spLocks noChangeArrowheads="1"/>
              </p:cNvSpPr>
              <p:nvPr/>
            </p:nvSpPr>
            <p:spPr bwMode="auto">
              <a:xfrm>
                <a:off x="2044042" y="1924156"/>
                <a:ext cx="1014856" cy="3973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r">
                  <a:lnSpc>
                    <a:spcPct val="150000"/>
                  </a:lnSpc>
                  <a:spcBef>
                    <a:spcPts val="400"/>
                  </a:spcBef>
                  <a:buFontTx/>
                  <a:buNone/>
                </a:pPr>
                <a:r>
                  <a:rPr kumimoji="0"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ns1∆Sir2-A</a:t>
                </a:r>
                <a:endParaRPr kumimoji="0"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직사각형 20"/>
              <p:cNvSpPr>
                <a:spLocks noChangeArrowheads="1"/>
              </p:cNvSpPr>
              <p:nvPr/>
            </p:nvSpPr>
            <p:spPr bwMode="auto">
              <a:xfrm>
                <a:off x="2044041" y="2131113"/>
                <a:ext cx="1006450" cy="3973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algn="r">
                  <a:lnSpc>
                    <a:spcPct val="150000"/>
                  </a:lnSpc>
                  <a:spcBef>
                    <a:spcPts val="400"/>
                  </a:spcBef>
                  <a:buFontTx/>
                  <a:buNone/>
                </a:pPr>
                <a:r>
                  <a:rPr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ns1</a:t>
                </a:r>
                <a:r>
                  <a:rPr kumimoji="0" lang="en-US" altLang="ko-KR" sz="95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∆Sir2-E</a:t>
                </a:r>
                <a:endParaRPr kumimoji="0" lang="en-US" altLang="ko-KR" sz="9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" name="TextBox 3"/>
            <p:cNvSpPr txBox="1"/>
            <p:nvPr/>
          </p:nvSpPr>
          <p:spPr>
            <a:xfrm>
              <a:off x="2727975" y="2967388"/>
              <a:ext cx="1066677" cy="3041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5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PD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812175" y="2967388"/>
              <a:ext cx="1066676" cy="3041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5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 M NaCl</a:t>
              </a: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469591" y="2493033"/>
            <a:ext cx="2466417" cy="1480931"/>
            <a:chOff x="1967025" y="3279740"/>
            <a:chExt cx="3499415" cy="2101181"/>
          </a:xfrm>
        </p:grpSpPr>
        <p:pic>
          <p:nvPicPr>
            <p:cNvPr id="17" name="그림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97528" y="3773029"/>
              <a:ext cx="757147" cy="766166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8" name="그림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297525" y="4584549"/>
              <a:ext cx="762715" cy="76616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9" name="그림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092477" y="3773029"/>
              <a:ext cx="757147" cy="76616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0" name="그림 8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107921" y="4584549"/>
              <a:ext cx="741705" cy="766164"/>
            </a:xfrm>
            <a:prstGeom prst="rect">
              <a:avLst/>
            </a:prstGeom>
            <a:ln>
              <a:noFill/>
            </a:ln>
          </p:spPr>
        </p:pic>
        <p:sp>
          <p:nvSpPr>
            <p:cNvPr id="21" name="TextBox 20"/>
            <p:cNvSpPr txBox="1"/>
            <p:nvPr/>
          </p:nvSpPr>
          <p:spPr>
            <a:xfrm>
              <a:off x="2297525" y="3454412"/>
              <a:ext cx="757149" cy="3056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ko-KR" alt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092479" y="3454412"/>
              <a:ext cx="741440" cy="3056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2∆</a:t>
              </a:r>
              <a:endParaRPr lang="ko-KR" alt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3" name="그림 39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896777" y="3773029"/>
              <a:ext cx="757147" cy="76616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4" name="그림 40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896778" y="4587725"/>
              <a:ext cx="751742" cy="76616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5" name="그림 52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701256" y="3773029"/>
              <a:ext cx="757147" cy="76616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6" name="그림 5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700273" y="4587725"/>
              <a:ext cx="766167" cy="766165"/>
            </a:xfrm>
            <a:prstGeom prst="rect">
              <a:avLst/>
            </a:prstGeom>
            <a:ln>
              <a:noFill/>
            </a:ln>
          </p:spPr>
        </p:pic>
        <p:sp>
          <p:nvSpPr>
            <p:cNvPr id="27" name="TextBox 26"/>
            <p:cNvSpPr txBox="1"/>
            <p:nvPr/>
          </p:nvSpPr>
          <p:spPr>
            <a:xfrm>
              <a:off x="3923294" y="3279741"/>
              <a:ext cx="766167" cy="48034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ns1∆</a:t>
              </a:r>
            </a:p>
            <a:p>
              <a:pPr algn="ctr"/>
              <a:r>
                <a:rPr lang="en-US" altLang="ko-KR" sz="8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2-A</a:t>
              </a:r>
              <a:endParaRPr lang="ko-KR" alt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648518" y="3279740"/>
              <a:ext cx="788262" cy="48034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ns1∆</a:t>
              </a:r>
            </a:p>
            <a:p>
              <a:pPr algn="ctr"/>
              <a:r>
                <a:rPr lang="en-US" altLang="ko-KR" sz="8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2-E</a:t>
              </a:r>
              <a:endParaRPr lang="ko-KR" alt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6200000">
              <a:off x="1757735" y="4003218"/>
              <a:ext cx="724259" cy="3056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C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1671347" y="4779566"/>
              <a:ext cx="897033" cy="3056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in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0" name="TextBox 49"/>
          <p:cNvSpPr txBox="1"/>
          <p:nvPr/>
        </p:nvSpPr>
        <p:spPr>
          <a:xfrm>
            <a:off x="273050" y="584679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72872" y="2397437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80999" y="4381243"/>
            <a:ext cx="54356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n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a part of TORC1 signaling, is involved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regulation through Sir2 phosphorylation a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73. (a)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lt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ss resistance was analyzed by spotting indicated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 on YPD with or without 0.8M NaCl, and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tes wer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ed for 3 day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cuolar acidity was determined as indicated by quinacrine staining of exponentially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ing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&gt;100 cells for all strains. A representative image is shown for each strain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" name="Group 30"/>
          <p:cNvGrpSpPr/>
          <p:nvPr/>
        </p:nvGrpSpPr>
        <p:grpSpPr>
          <a:xfrm>
            <a:off x="3033168" y="2712533"/>
            <a:ext cx="1440000" cy="1620000"/>
            <a:chOff x="4376694" y="2765400"/>
            <a:chExt cx="1440000" cy="1620000"/>
          </a:xfrm>
        </p:grpSpPr>
        <p:graphicFrame>
          <p:nvGraphicFramePr>
            <p:cNvPr id="32" name="Chart 3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48711837"/>
                </p:ext>
              </p:extLst>
            </p:nvPr>
          </p:nvGraphicFramePr>
          <p:xfrm>
            <a:off x="4376694" y="2765400"/>
            <a:ext cx="144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pSp>
          <p:nvGrpSpPr>
            <p:cNvPr id="66" name="Group 65"/>
            <p:cNvGrpSpPr/>
            <p:nvPr/>
          </p:nvGrpSpPr>
          <p:grpSpPr>
            <a:xfrm>
              <a:off x="5062251" y="3048874"/>
              <a:ext cx="672895" cy="250270"/>
              <a:chOff x="3973261" y="670780"/>
              <a:chExt cx="807300" cy="250270"/>
            </a:xfrm>
          </p:grpSpPr>
          <p:grpSp>
            <p:nvGrpSpPr>
              <p:cNvPr id="67" name="Group 66"/>
              <p:cNvGrpSpPr/>
              <p:nvPr/>
            </p:nvGrpSpPr>
            <p:grpSpPr>
              <a:xfrm>
                <a:off x="3973261" y="670780"/>
                <a:ext cx="807300" cy="226986"/>
                <a:chOff x="8921079" y="4773267"/>
                <a:chExt cx="1187255" cy="196533"/>
              </a:xfrm>
            </p:grpSpPr>
            <p:cxnSp>
              <p:nvCxnSpPr>
                <p:cNvPr id="74" name="직선 연결선 33"/>
                <p:cNvCxnSpPr/>
                <p:nvPr/>
              </p:nvCxnSpPr>
              <p:spPr>
                <a:xfrm>
                  <a:off x="8926251" y="4969800"/>
                  <a:ext cx="36373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직선 연결선 30"/>
                <p:cNvCxnSpPr/>
                <p:nvPr/>
              </p:nvCxnSpPr>
              <p:spPr>
                <a:xfrm>
                  <a:off x="9647084" y="4899043"/>
                  <a:ext cx="325154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직선 연결선 28"/>
                <p:cNvCxnSpPr/>
                <p:nvPr/>
              </p:nvCxnSpPr>
              <p:spPr>
                <a:xfrm>
                  <a:off x="8921079" y="4899110"/>
                  <a:ext cx="65506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7" name="직사각형 26"/>
                <p:cNvSpPr/>
                <p:nvPr/>
              </p:nvSpPr>
              <p:spPr>
                <a:xfrm>
                  <a:off x="9510990" y="4773267"/>
                  <a:ext cx="597344" cy="18653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*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직사각형 26"/>
                <p:cNvSpPr/>
                <p:nvPr/>
              </p:nvSpPr>
              <p:spPr>
                <a:xfrm>
                  <a:off x="8943787" y="4780691"/>
                  <a:ext cx="497894" cy="18653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*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68" name="Straight Connector 67"/>
              <p:cNvCxnSpPr/>
              <p:nvPr/>
            </p:nvCxnSpPr>
            <p:spPr>
              <a:xfrm>
                <a:off x="3973397" y="818799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>
                <a:off x="4414599" y="818799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/>
              <p:nvPr/>
            </p:nvCxnSpPr>
            <p:spPr>
              <a:xfrm>
                <a:off x="3975532" y="895850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/>
              <p:cNvCxnSpPr/>
              <p:nvPr/>
            </p:nvCxnSpPr>
            <p:spPr>
              <a:xfrm>
                <a:off x="4222285" y="895850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>
                <a:off x="4468390" y="818799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>
                <a:off x="4688024" y="818799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2636964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327336" y="2518883"/>
            <a:ext cx="52765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Sch9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not required for regulation of PMA1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. 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levels were measured i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, 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r2∆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ch9∆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s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R (*p&lt;0.0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PCR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eletion of SCH9 did affect PMA1 expression as compared to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2016084" y="761603"/>
            <a:ext cx="1355766" cy="1620000"/>
            <a:chOff x="2016084" y="761603"/>
            <a:chExt cx="1355766" cy="162000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1016764"/>
                </p:ext>
              </p:extLst>
            </p:nvPr>
          </p:nvGraphicFramePr>
          <p:xfrm>
            <a:off x="2016084" y="761603"/>
            <a:ext cx="1355766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20" name="Group 19"/>
            <p:cNvGrpSpPr/>
            <p:nvPr/>
          </p:nvGrpSpPr>
          <p:grpSpPr>
            <a:xfrm>
              <a:off x="2622003" y="964959"/>
              <a:ext cx="511687" cy="409336"/>
              <a:chOff x="2622003" y="964959"/>
              <a:chExt cx="511687" cy="409336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2625082" y="964959"/>
                <a:ext cx="457419" cy="409336"/>
                <a:chOff x="4319149" y="4550297"/>
                <a:chExt cx="544089" cy="768356"/>
              </a:xfrm>
            </p:grpSpPr>
            <p:sp>
              <p:nvSpPr>
                <p:cNvPr id="9" name="TextBox 8"/>
                <p:cNvSpPr txBox="1"/>
                <p:nvPr/>
              </p:nvSpPr>
              <p:spPr>
                <a:xfrm>
                  <a:off x="4426215" y="4550297"/>
                  <a:ext cx="437023" cy="4044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.S.</a:t>
                  </a: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4319149" y="4914248"/>
                  <a:ext cx="355707" cy="4044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0" name="Group 9"/>
              <p:cNvGrpSpPr/>
              <p:nvPr/>
            </p:nvGrpSpPr>
            <p:grpSpPr>
              <a:xfrm>
                <a:off x="2622003" y="1129352"/>
                <a:ext cx="511687" cy="25655"/>
                <a:chOff x="3773028" y="1890065"/>
                <a:chExt cx="371270" cy="22898"/>
              </a:xfrm>
            </p:grpSpPr>
            <p:cxnSp>
              <p:nvCxnSpPr>
                <p:cNvPr id="14" name="직선 연결선 28"/>
                <p:cNvCxnSpPr/>
                <p:nvPr/>
              </p:nvCxnSpPr>
              <p:spPr>
                <a:xfrm>
                  <a:off x="3773028" y="1890065"/>
                  <a:ext cx="37127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/>
                <p:cNvCxnSpPr/>
                <p:nvPr/>
              </p:nvCxnSpPr>
              <p:spPr>
                <a:xfrm>
                  <a:off x="3773031" y="1890466"/>
                  <a:ext cx="0" cy="2249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/>
                <p:cNvCxnSpPr/>
                <p:nvPr/>
              </p:nvCxnSpPr>
              <p:spPr>
                <a:xfrm>
                  <a:off x="4142731" y="1890471"/>
                  <a:ext cx="0" cy="2249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" name="Group 1"/>
              <p:cNvGrpSpPr/>
              <p:nvPr/>
            </p:nvGrpSpPr>
            <p:grpSpPr>
              <a:xfrm>
                <a:off x="2622008" y="1293644"/>
                <a:ext cx="276234" cy="25200"/>
                <a:chOff x="3925430" y="2042366"/>
                <a:chExt cx="371270" cy="23906"/>
              </a:xfrm>
            </p:grpSpPr>
            <p:cxnSp>
              <p:nvCxnSpPr>
                <p:cNvPr id="17" name="직선 연결선 28"/>
                <p:cNvCxnSpPr/>
                <p:nvPr/>
              </p:nvCxnSpPr>
              <p:spPr>
                <a:xfrm>
                  <a:off x="3925430" y="2042465"/>
                  <a:ext cx="37127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/>
                <p:cNvCxnSpPr/>
                <p:nvPr/>
              </p:nvCxnSpPr>
              <p:spPr>
                <a:xfrm>
                  <a:off x="3925430" y="2042366"/>
                  <a:ext cx="0" cy="2390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/>
                <p:cNvCxnSpPr/>
                <p:nvPr/>
              </p:nvCxnSpPr>
              <p:spPr>
                <a:xfrm>
                  <a:off x="4295132" y="2042366"/>
                  <a:ext cx="0" cy="2390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209663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765453" y="749632"/>
            <a:ext cx="2439347" cy="1046899"/>
            <a:chOff x="334536" y="985159"/>
            <a:chExt cx="2439347" cy="1046899"/>
          </a:xfrm>
        </p:grpSpPr>
        <p:grpSp>
          <p:nvGrpSpPr>
            <p:cNvPr id="2" name="Group 1"/>
            <p:cNvGrpSpPr/>
            <p:nvPr/>
          </p:nvGrpSpPr>
          <p:grpSpPr>
            <a:xfrm>
              <a:off x="334536" y="1069818"/>
              <a:ext cx="2439347" cy="962240"/>
              <a:chOff x="378900" y="2554417"/>
              <a:chExt cx="3252462" cy="1282987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378900" y="2554417"/>
                <a:ext cx="3188739" cy="1017068"/>
                <a:chOff x="798936" y="2530232"/>
                <a:chExt cx="3823953" cy="1151031"/>
              </a:xfrm>
            </p:grpSpPr>
            <p:grpSp>
              <p:nvGrpSpPr>
                <p:cNvPr id="5" name="Group 4"/>
                <p:cNvGrpSpPr/>
                <p:nvPr/>
              </p:nvGrpSpPr>
              <p:grpSpPr>
                <a:xfrm>
                  <a:off x="798936" y="2530232"/>
                  <a:ext cx="3823953" cy="1151031"/>
                  <a:chOff x="1010971" y="2074966"/>
                  <a:chExt cx="3823953" cy="1151031"/>
                </a:xfrm>
              </p:grpSpPr>
              <p:pic>
                <p:nvPicPr>
                  <p:cNvPr id="7" name="Picture 6"/>
                  <p:cNvPicPr>
                    <a:picLocks/>
                  </p:cNvPicPr>
                  <p:nvPr/>
                </p:nvPicPr>
                <p:blipFill rotWithShape="1">
                  <a:blip r:embed="rId2"/>
                  <a:srcRect l="24105" t="2770" r="25802" b="40137"/>
                  <a:stretch/>
                </p:blipFill>
                <p:spPr>
                  <a:xfrm>
                    <a:off x="3614613" y="2074966"/>
                    <a:ext cx="1220311" cy="1064718"/>
                  </a:xfrm>
                  <a:prstGeom prst="rect">
                    <a:avLst/>
                  </a:prstGeom>
                </p:spPr>
              </p:pic>
              <p:sp>
                <p:nvSpPr>
                  <p:cNvPr id="8" name="TextBox 7"/>
                  <p:cNvSpPr txBox="1"/>
                  <p:nvPr/>
                </p:nvSpPr>
                <p:spPr>
                  <a:xfrm>
                    <a:off x="1010971" y="2755771"/>
                    <a:ext cx="1452472" cy="47022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defPPr>
                      <a:defRPr lang="ko-KR"/>
                    </a:defPPr>
                    <a:lvl1pPr algn="r">
                      <a:lnSpc>
                        <a:spcPct val="150000"/>
                      </a:lnSpc>
                      <a:spcBef>
                        <a:spcPts val="400"/>
                      </a:spcBef>
                      <a:buFontTx/>
                      <a:buNone/>
                      <a:defRPr sz="1400" i="1">
                        <a:latin typeface="Century Gothic" pitchFamily="34" charset="0"/>
                        <a:ea typeface="맑은 고딕" pitchFamily="50" charset="-127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charset="0"/>
                      <a:buChar char="–"/>
                      <a:defRPr sz="2800">
                        <a:latin typeface="맑은 고딕" pitchFamily="50" charset="-127"/>
                        <a:ea typeface="맑은 고딕" pitchFamily="50" charset="-127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charset="0"/>
                      <a:buChar char="•"/>
                      <a:defRPr sz="2400">
                        <a:latin typeface="맑은 고딕" pitchFamily="50" charset="-127"/>
                        <a:ea typeface="맑은 고딕" pitchFamily="50" charset="-127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charset="0"/>
                      <a:buChar char="–"/>
                      <a:defRPr sz="2000">
                        <a:latin typeface="맑은 고딕" pitchFamily="50" charset="-127"/>
                        <a:ea typeface="맑은 고딕" pitchFamily="50" charset="-127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charset="0"/>
                      <a:buChar char="»"/>
                      <a:defRPr sz="2000">
                        <a:latin typeface="맑은 고딕" pitchFamily="50" charset="-127"/>
                        <a:ea typeface="맑은 고딕" pitchFamily="50" charset="-127"/>
                      </a:defRPr>
                    </a:lvl5pPr>
                    <a:lvl6pPr marL="2514600" indent="-228600" fontAlgn="base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latin typeface="맑은 고딕" pitchFamily="50" charset="-127"/>
                        <a:ea typeface="맑은 고딕" pitchFamily="50" charset="-127"/>
                      </a:defRPr>
                    </a:lvl6pPr>
                    <a:lvl7pPr marL="2971800" indent="-228600" fontAlgn="base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latin typeface="맑은 고딕" pitchFamily="50" charset="-127"/>
                        <a:ea typeface="맑은 고딕" pitchFamily="50" charset="-127"/>
                      </a:defRPr>
                    </a:lvl7pPr>
                    <a:lvl8pPr marL="3429000" indent="-228600" fontAlgn="base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latin typeface="맑은 고딕" pitchFamily="50" charset="-127"/>
                        <a:ea typeface="맑은 고딕" pitchFamily="50" charset="-127"/>
                      </a:defRPr>
                    </a:lvl8pPr>
                    <a:lvl9pPr marL="3886200" indent="-228600" fontAlgn="base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latin typeface="맑은 고딕" pitchFamily="50" charset="-127"/>
                        <a:ea typeface="맑은 고딕" pitchFamily="50" charset="-127"/>
                      </a:defRPr>
                    </a:lvl9pPr>
                  </a:lstStyle>
                  <a:p>
                    <a:r>
                      <a:rPr lang="en-US" altLang="ko-KR" sz="95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de2</a:t>
                    </a:r>
                    <a:r>
                      <a:rPr lang="el-GR" altLang="ko-KR" sz="950" i="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Δ</a:t>
                    </a:r>
                    <a:r>
                      <a:rPr lang="en-US" altLang="ko-KR" sz="95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tor1</a:t>
                    </a:r>
                    <a:r>
                      <a:rPr lang="el-GR" altLang="ko-KR" sz="95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Δ</a:t>
                    </a:r>
                    <a:endParaRPr lang="en-US" altLang="ko-KR" sz="950" i="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pic>
              <p:nvPicPr>
                <p:cNvPr id="6" name="Picture 5"/>
                <p:cNvPicPr>
                  <a:picLocks/>
                </p:cNvPicPr>
                <p:nvPr/>
              </p:nvPicPr>
              <p:blipFill rotWithShape="1">
                <a:blip r:embed="rId3"/>
                <a:srcRect l="21632" t="1910" r="26659" b="36365"/>
                <a:stretch/>
              </p:blipFill>
              <p:spPr>
                <a:xfrm>
                  <a:off x="2153308" y="2531885"/>
                  <a:ext cx="1220312" cy="1064718"/>
                </a:xfrm>
                <a:prstGeom prst="rect">
                  <a:avLst/>
                </a:prstGeom>
              </p:spPr>
            </p:pic>
          </p:grpSp>
          <p:sp>
            <p:nvSpPr>
              <p:cNvPr id="4" name="TextBox 3"/>
              <p:cNvSpPr txBox="1"/>
              <p:nvPr/>
            </p:nvSpPr>
            <p:spPr>
              <a:xfrm>
                <a:off x="1508289" y="3519368"/>
                <a:ext cx="2123073" cy="3180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</a:t>
                </a:r>
                <a:r>
                  <a:rPr lang="en-US" sz="9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PD            0.8M </a:t>
                </a:r>
                <a:r>
                  <a:rPr lang="en-US" sz="9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Cl</a:t>
                </a:r>
              </a:p>
            </p:txBody>
          </p:sp>
        </p:grpSp>
        <p:sp>
          <p:nvSpPr>
            <p:cNvPr id="18" name="Rectangle 17"/>
            <p:cNvSpPr/>
            <p:nvPr/>
          </p:nvSpPr>
          <p:spPr>
            <a:xfrm>
              <a:off x="841763" y="985159"/>
              <a:ext cx="375424" cy="3139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>
                <a:lnSpc>
                  <a:spcPct val="150000"/>
                </a:lnSpc>
                <a:spcBef>
                  <a:spcPts val="400"/>
                </a:spcBef>
              </a:pPr>
              <a:r>
                <a:rPr lang="en-US" altLang="ko-KR" sz="950" i="1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764028" y="1190015"/>
              <a:ext cx="481222" cy="285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>
                <a:lnSpc>
                  <a:spcPct val="150000"/>
                </a:lnSpc>
                <a:spcBef>
                  <a:spcPts val="400"/>
                </a:spcBef>
              </a:pPr>
              <a:r>
                <a:rPr lang="en-US" altLang="ko-KR" sz="950" i="1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</a:rPr>
                <a:t>tor1</a:t>
              </a:r>
              <a:r>
                <a:rPr lang="el-GR" altLang="ko-KR" sz="950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</a:rPr>
                <a:t>Δ</a:t>
              </a:r>
              <a:endParaRPr lang="en-US" altLang="ko-KR" sz="950" dirty="0">
                <a:latin typeface="Times New Roman" panose="02020603050405020304" pitchFamily="18" charset="0"/>
                <a:ea typeface="맑은 고딕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699195" y="1350339"/>
              <a:ext cx="543739" cy="285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>
                <a:lnSpc>
                  <a:spcPct val="150000"/>
                </a:lnSpc>
                <a:spcBef>
                  <a:spcPts val="400"/>
                </a:spcBef>
              </a:pPr>
              <a:r>
                <a:rPr lang="en-US" altLang="ko-KR" sz="950" i="1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</a:rPr>
                <a:t>pde2</a:t>
              </a:r>
              <a:r>
                <a:rPr lang="el-GR" altLang="ko-KR" sz="950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</a:rPr>
                <a:t>Δ</a:t>
              </a:r>
              <a:endParaRPr lang="en-US" altLang="ko-KR" sz="950" dirty="0">
                <a:latin typeface="Times New Roman" panose="02020603050405020304" pitchFamily="18" charset="0"/>
                <a:ea typeface="맑은 고딕" pitchFamily="50" charset="-127"/>
                <a:cs typeface="Times New Roman" panose="02020603050405020304" pitchFamily="18" charset="0"/>
              </a:endParaRP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611943" y="582042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231639" y="582041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67123" y="2255152"/>
            <a:ext cx="501927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RC1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 partially reduces PMA1 expression in PKA activating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. (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t stress resistance was analyzed by spotting indicated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 on YPD with or without 0.8M NaCl, and plates were incubated for 3 days.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r1∆pde2∆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 partially rescues the salt stress susceptibility of 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de2∆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. (b)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A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levels were measured in indicated strains by qPCR. ***p&lt;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01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e2∆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r1∆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p&lt; 0.0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r1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∆ vs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r1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∆pde2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3579811" y="598903"/>
            <a:ext cx="1440000" cy="1620000"/>
            <a:chOff x="3579811" y="598903"/>
            <a:chExt cx="1440000" cy="1620000"/>
          </a:xfrm>
        </p:grpSpPr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56966600"/>
                </p:ext>
              </p:extLst>
            </p:nvPr>
          </p:nvGraphicFramePr>
          <p:xfrm>
            <a:off x="3579811" y="598903"/>
            <a:ext cx="144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26" name="Group 25"/>
            <p:cNvGrpSpPr/>
            <p:nvPr/>
          </p:nvGrpSpPr>
          <p:grpSpPr>
            <a:xfrm>
              <a:off x="4155364" y="822156"/>
              <a:ext cx="743127" cy="247103"/>
              <a:chOff x="3973267" y="676891"/>
              <a:chExt cx="743127" cy="247103"/>
            </a:xfrm>
          </p:grpSpPr>
          <p:grpSp>
            <p:nvGrpSpPr>
              <p:cNvPr id="27" name="Group 26"/>
              <p:cNvGrpSpPr/>
              <p:nvPr/>
            </p:nvGrpSpPr>
            <p:grpSpPr>
              <a:xfrm>
                <a:off x="3973267" y="676891"/>
                <a:ext cx="743127" cy="220884"/>
                <a:chOff x="8921079" y="4778542"/>
                <a:chExt cx="1092878" cy="191249"/>
              </a:xfrm>
            </p:grpSpPr>
            <p:cxnSp>
              <p:nvCxnSpPr>
                <p:cNvPr id="34" name="직선 연결선 33"/>
                <p:cNvCxnSpPr/>
                <p:nvPr/>
              </p:nvCxnSpPr>
              <p:spPr>
                <a:xfrm>
                  <a:off x="8928118" y="4969791"/>
                  <a:ext cx="36372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직선 연결선 30"/>
                <p:cNvCxnSpPr/>
                <p:nvPr/>
              </p:nvCxnSpPr>
              <p:spPr>
                <a:xfrm>
                  <a:off x="9647084" y="4899043"/>
                  <a:ext cx="325154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직선 연결선 28"/>
                <p:cNvCxnSpPr/>
                <p:nvPr/>
              </p:nvCxnSpPr>
              <p:spPr>
                <a:xfrm>
                  <a:off x="8921079" y="4899110"/>
                  <a:ext cx="65506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7" name="직사각형 26"/>
                <p:cNvSpPr/>
                <p:nvPr/>
              </p:nvSpPr>
              <p:spPr>
                <a:xfrm>
                  <a:off x="9591502" y="4778542"/>
                  <a:ext cx="422455" cy="18653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직사각형 26"/>
                <p:cNvSpPr/>
                <p:nvPr/>
              </p:nvSpPr>
              <p:spPr>
                <a:xfrm>
                  <a:off x="8943787" y="4780691"/>
                  <a:ext cx="497894" cy="18653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*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28" name="Straight Connector 27"/>
              <p:cNvCxnSpPr/>
              <p:nvPr/>
            </p:nvCxnSpPr>
            <p:spPr>
              <a:xfrm>
                <a:off x="3976133" y="816024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4418409" y="816024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3976133" y="898794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4221015" y="898794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>
                <a:off x="4468391" y="814309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>
                <a:off x="4684214" y="814309"/>
                <a:ext cx="0" cy="25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981401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236446"/>
              </p:ext>
            </p:extLst>
          </p:nvPr>
        </p:nvGraphicFramePr>
        <p:xfrm>
          <a:off x="3092260" y="1810700"/>
          <a:ext cx="2612710" cy="24510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Rectangle 2"/>
          <p:cNvSpPr/>
          <p:nvPr/>
        </p:nvSpPr>
        <p:spPr>
          <a:xfrm>
            <a:off x="468557" y="4659178"/>
            <a:ext cx="5103187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(a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l-G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s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l-G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l-G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s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. p &lt; 0.0001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p &lt; 0.05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s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p &lt; 0.0001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s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(b) R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l-G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r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l-G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l-G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r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. p &lt; 0.0001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p &lt; 0.0001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r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p 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 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2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b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r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dirty="0"/>
              <a:t>.</a:t>
            </a:r>
            <a:r>
              <a:rPr lang="en-US" i="1" dirty="0"/>
              <a:t>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72 for all strains. RLS was measured by micromanipulation. The mean lifespan is indicated.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har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7135924"/>
              </p:ext>
            </p:extLst>
          </p:nvPr>
        </p:nvGraphicFramePr>
        <p:xfrm>
          <a:off x="454191" y="1810701"/>
          <a:ext cx="2612709" cy="24510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90463" y="1533701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910159" y="1533701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092340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4</TotalTime>
  <Words>886</Words>
  <Application>Microsoft Office PowerPoint</Application>
  <PresentationFormat>사용자 지정</PresentationFormat>
  <Paragraphs>112</Paragraphs>
  <Slides>8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4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yur Devare</dc:creator>
  <cp:lastModifiedBy>Windows User</cp:lastModifiedBy>
  <cp:revision>52</cp:revision>
  <dcterms:created xsi:type="dcterms:W3CDTF">2019-05-03T06:16:25Z</dcterms:created>
  <dcterms:modified xsi:type="dcterms:W3CDTF">2020-03-21T01:58:44Z</dcterms:modified>
</cp:coreProperties>
</file>